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BAF91B4-5F2A-497D-B562-74C214A90708}" v="26" dt="2023-12-21T04:49:08.75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7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mindi Seneviratne" userId="dccaeb4cfbf7da8e" providerId="LiveId" clId="{BBAF91B4-5F2A-497D-B562-74C214A90708}"/>
    <pc:docChg chg="undo custSel modSld">
      <pc:chgData name="Chamindi Seneviratne" userId="dccaeb4cfbf7da8e" providerId="LiveId" clId="{BBAF91B4-5F2A-497D-B562-74C214A90708}" dt="2023-12-21T04:49:12.476" v="884" actId="1076"/>
      <pc:docMkLst>
        <pc:docMk/>
      </pc:docMkLst>
      <pc:sldChg chg="addSp delSp modSp mod">
        <pc:chgData name="Chamindi Seneviratne" userId="dccaeb4cfbf7da8e" providerId="LiveId" clId="{BBAF91B4-5F2A-497D-B562-74C214A90708}" dt="2023-12-21T04:49:12.476" v="884" actId="1076"/>
        <pc:sldMkLst>
          <pc:docMk/>
          <pc:sldMk cId="173754885" sldId="257"/>
        </pc:sldMkLst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5" creationId="{CC0856AD-92DE-B022-2FBA-6B89593B06B3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8" creationId="{B8C681DF-8AFD-7114-AB6C-D002D0CD0461}"/>
          </ac:spMkLst>
        </pc:spChg>
        <pc:spChg chg="mod">
          <ac:chgData name="Chamindi Seneviratne" userId="dccaeb4cfbf7da8e" providerId="LiveId" clId="{BBAF91B4-5F2A-497D-B562-74C214A90708}" dt="2023-12-21T04:27:42.286" v="459" actId="20577"/>
          <ac:spMkLst>
            <pc:docMk/>
            <pc:sldMk cId="173754885" sldId="257"/>
            <ac:spMk id="9" creationId="{AC019AAE-0694-5C7A-AFB6-2D645220891B}"/>
          </ac:spMkLst>
        </pc:spChg>
        <pc:spChg chg="del mod">
          <ac:chgData name="Chamindi Seneviratne" userId="dccaeb4cfbf7da8e" providerId="LiveId" clId="{BBAF91B4-5F2A-497D-B562-74C214A90708}" dt="2023-12-21T04:25:58.045" v="415" actId="478"/>
          <ac:spMkLst>
            <pc:docMk/>
            <pc:sldMk cId="173754885" sldId="257"/>
            <ac:spMk id="11" creationId="{73DC4809-6E75-AE04-9D8D-CA3BD42E39AE}"/>
          </ac:spMkLst>
        </pc:spChg>
        <pc:spChg chg="del mod">
          <ac:chgData name="Chamindi Seneviratne" userId="dccaeb4cfbf7da8e" providerId="LiveId" clId="{BBAF91B4-5F2A-497D-B562-74C214A90708}" dt="2023-12-21T04:25:44.479" v="409" actId="478"/>
          <ac:spMkLst>
            <pc:docMk/>
            <pc:sldMk cId="173754885" sldId="257"/>
            <ac:spMk id="12" creationId="{1CFE925E-CC73-CE2A-F31D-D12D4F90DD20}"/>
          </ac:spMkLst>
        </pc:spChg>
        <pc:spChg chg="del mod">
          <ac:chgData name="Chamindi Seneviratne" userId="dccaeb4cfbf7da8e" providerId="LiveId" clId="{BBAF91B4-5F2A-497D-B562-74C214A90708}" dt="2023-12-21T04:26:30.446" v="433" actId="478"/>
          <ac:spMkLst>
            <pc:docMk/>
            <pc:sldMk cId="173754885" sldId="257"/>
            <ac:spMk id="13" creationId="{DB67B02E-2A4E-B1EA-C119-EB08F9A09BD0}"/>
          </ac:spMkLst>
        </pc:spChg>
        <pc:spChg chg="del mod">
          <ac:chgData name="Chamindi Seneviratne" userId="dccaeb4cfbf7da8e" providerId="LiveId" clId="{BBAF91B4-5F2A-497D-B562-74C214A90708}" dt="2023-12-21T04:25:44.479" v="409" actId="478"/>
          <ac:spMkLst>
            <pc:docMk/>
            <pc:sldMk cId="173754885" sldId="257"/>
            <ac:spMk id="14" creationId="{5269607C-C043-3157-5BA6-E83C9516FDEA}"/>
          </ac:spMkLst>
        </pc:spChg>
        <pc:spChg chg="del mod">
          <ac:chgData name="Chamindi Seneviratne" userId="dccaeb4cfbf7da8e" providerId="LiveId" clId="{BBAF91B4-5F2A-497D-B562-74C214A90708}" dt="2023-12-21T04:25:44.479" v="409" actId="478"/>
          <ac:spMkLst>
            <pc:docMk/>
            <pc:sldMk cId="173754885" sldId="257"/>
            <ac:spMk id="15" creationId="{9CD54B1A-03EB-267F-ECC6-D3A21C87F3C3}"/>
          </ac:spMkLst>
        </pc:spChg>
        <pc:spChg chg="del mod">
          <ac:chgData name="Chamindi Seneviratne" userId="dccaeb4cfbf7da8e" providerId="LiveId" clId="{BBAF91B4-5F2A-497D-B562-74C214A90708}" dt="2023-12-21T04:25:51.967" v="412" actId="478"/>
          <ac:spMkLst>
            <pc:docMk/>
            <pc:sldMk cId="173754885" sldId="257"/>
            <ac:spMk id="16" creationId="{8BE37F0A-DEE5-3EB1-0370-99EF7E3146B4}"/>
          </ac:spMkLst>
        </pc:spChg>
        <pc:spChg chg="del mod">
          <ac:chgData name="Chamindi Seneviratne" userId="dccaeb4cfbf7da8e" providerId="LiveId" clId="{BBAF91B4-5F2A-497D-B562-74C214A90708}" dt="2023-12-21T04:26:00.870" v="417" actId="478"/>
          <ac:spMkLst>
            <pc:docMk/>
            <pc:sldMk cId="173754885" sldId="257"/>
            <ac:spMk id="17" creationId="{7419B7EE-F818-1AFD-B603-83767F59EE41}"/>
          </ac:spMkLst>
        </pc:spChg>
        <pc:spChg chg="del mod">
          <ac:chgData name="Chamindi Seneviratne" userId="dccaeb4cfbf7da8e" providerId="LiveId" clId="{BBAF91B4-5F2A-497D-B562-74C214A90708}" dt="2023-12-21T04:25:44.479" v="409" actId="478"/>
          <ac:spMkLst>
            <pc:docMk/>
            <pc:sldMk cId="173754885" sldId="257"/>
            <ac:spMk id="18" creationId="{EE45CFB2-20AF-C6DE-D9F4-096FD621D729}"/>
          </ac:spMkLst>
        </pc:spChg>
        <pc:spChg chg="del mod">
          <ac:chgData name="Chamindi Seneviratne" userId="dccaeb4cfbf7da8e" providerId="LiveId" clId="{BBAF91B4-5F2A-497D-B562-74C214A90708}" dt="2023-12-21T04:25:44.479" v="409" actId="478"/>
          <ac:spMkLst>
            <pc:docMk/>
            <pc:sldMk cId="173754885" sldId="257"/>
            <ac:spMk id="19" creationId="{952CCB8F-7DFC-254B-6237-D7EFD579169D}"/>
          </ac:spMkLst>
        </pc:spChg>
        <pc:spChg chg="del mod">
          <ac:chgData name="Chamindi Seneviratne" userId="dccaeb4cfbf7da8e" providerId="LiveId" clId="{BBAF91B4-5F2A-497D-B562-74C214A90708}" dt="2023-12-21T04:25:54.261" v="413" actId="478"/>
          <ac:spMkLst>
            <pc:docMk/>
            <pc:sldMk cId="173754885" sldId="257"/>
            <ac:spMk id="20" creationId="{01080808-5713-F735-C4CB-DF1F70772867}"/>
          </ac:spMkLst>
        </pc:spChg>
        <pc:spChg chg="del mod">
          <ac:chgData name="Chamindi Seneviratne" userId="dccaeb4cfbf7da8e" providerId="LiveId" clId="{BBAF91B4-5F2A-497D-B562-74C214A90708}" dt="2023-12-21T04:25:59.432" v="416" actId="478"/>
          <ac:spMkLst>
            <pc:docMk/>
            <pc:sldMk cId="173754885" sldId="257"/>
            <ac:spMk id="22" creationId="{FCB78B7B-DE05-7B38-2537-4F0F8F577748}"/>
          </ac:spMkLst>
        </pc:spChg>
        <pc:spChg chg="del mod">
          <ac:chgData name="Chamindi Seneviratne" userId="dccaeb4cfbf7da8e" providerId="LiveId" clId="{BBAF91B4-5F2A-497D-B562-74C214A90708}" dt="2023-12-21T04:25:56.040" v="414" actId="478"/>
          <ac:spMkLst>
            <pc:docMk/>
            <pc:sldMk cId="173754885" sldId="257"/>
            <ac:spMk id="23" creationId="{5D048B2D-4B90-A4E1-1C10-186F60307F9E}"/>
          </ac:spMkLst>
        </pc:spChg>
        <pc:spChg chg="del mod">
          <ac:chgData name="Chamindi Seneviratne" userId="dccaeb4cfbf7da8e" providerId="LiveId" clId="{BBAF91B4-5F2A-497D-B562-74C214A90708}" dt="2023-12-21T04:25:49.927" v="411" actId="478"/>
          <ac:spMkLst>
            <pc:docMk/>
            <pc:sldMk cId="173754885" sldId="257"/>
            <ac:spMk id="24" creationId="{FB06F47F-27BB-57AE-2FA4-C36B59DC20E4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25" creationId="{D77E5D3E-574D-1770-2BD9-3D7DFEE02886}"/>
          </ac:spMkLst>
        </pc:spChg>
        <pc:spChg chg="mod">
          <ac:chgData name="Chamindi Seneviratne" userId="dccaeb4cfbf7da8e" providerId="LiveId" clId="{BBAF91B4-5F2A-497D-B562-74C214A90708}" dt="2023-12-21T04:28:08.389" v="468" actId="20577"/>
          <ac:spMkLst>
            <pc:docMk/>
            <pc:sldMk cId="173754885" sldId="257"/>
            <ac:spMk id="26" creationId="{0BAFB107-B13A-967A-4D0B-31B19F45DFEF}"/>
          </ac:spMkLst>
        </pc:spChg>
        <pc:spChg chg="del mod">
          <ac:chgData name="Chamindi Seneviratne" userId="dccaeb4cfbf7da8e" providerId="LiveId" clId="{BBAF91B4-5F2A-497D-B562-74C214A90708}" dt="2023-12-21T04:28:54.166" v="484" actId="478"/>
          <ac:spMkLst>
            <pc:docMk/>
            <pc:sldMk cId="173754885" sldId="257"/>
            <ac:spMk id="29" creationId="{959C9703-0BF7-0557-F84A-C44D46E58C14}"/>
          </ac:spMkLst>
        </pc:spChg>
        <pc:spChg chg="del mod">
          <ac:chgData name="Chamindi Seneviratne" userId="dccaeb4cfbf7da8e" providerId="LiveId" clId="{BBAF91B4-5F2A-497D-B562-74C214A90708}" dt="2023-12-21T04:28:55.839" v="485" actId="478"/>
          <ac:spMkLst>
            <pc:docMk/>
            <pc:sldMk cId="173754885" sldId="257"/>
            <ac:spMk id="30" creationId="{01B0C629-21B6-2C29-026D-1012DD15DB94}"/>
          </ac:spMkLst>
        </pc:spChg>
        <pc:spChg chg="add del mod">
          <ac:chgData name="Chamindi Seneviratne" userId="dccaeb4cfbf7da8e" providerId="LiveId" clId="{BBAF91B4-5F2A-497D-B562-74C214A90708}" dt="2023-12-21T04:25:44.479" v="409" actId="478"/>
          <ac:spMkLst>
            <pc:docMk/>
            <pc:sldMk cId="173754885" sldId="257"/>
            <ac:spMk id="31" creationId="{B79C5FE7-46B5-1C81-4B73-9D36781D95A0}"/>
          </ac:spMkLst>
        </pc:spChg>
        <pc:spChg chg="del mod">
          <ac:chgData name="Chamindi Seneviratne" userId="dccaeb4cfbf7da8e" providerId="LiveId" clId="{BBAF91B4-5F2A-497D-B562-74C214A90708}" dt="2023-12-20T19:46:23.264" v="26" actId="478"/>
          <ac:spMkLst>
            <pc:docMk/>
            <pc:sldMk cId="173754885" sldId="257"/>
            <ac:spMk id="31" creationId="{BC337468-600A-49D1-CCF9-4D90A858CC39}"/>
          </ac:spMkLst>
        </pc:spChg>
        <pc:spChg chg="del mod">
          <ac:chgData name="Chamindi Seneviratne" userId="dccaeb4cfbf7da8e" providerId="LiveId" clId="{BBAF91B4-5F2A-497D-B562-74C214A90708}" dt="2023-12-21T04:28:57.436" v="486" actId="478"/>
          <ac:spMkLst>
            <pc:docMk/>
            <pc:sldMk cId="173754885" sldId="257"/>
            <ac:spMk id="32" creationId="{EAE68070-FF02-6859-019E-24267733809D}"/>
          </ac:spMkLst>
        </pc:spChg>
        <pc:spChg chg="del mod">
          <ac:chgData name="Chamindi Seneviratne" userId="dccaeb4cfbf7da8e" providerId="LiveId" clId="{BBAF91B4-5F2A-497D-B562-74C214A90708}" dt="2023-12-21T04:28:58.821" v="487" actId="478"/>
          <ac:spMkLst>
            <pc:docMk/>
            <pc:sldMk cId="173754885" sldId="257"/>
            <ac:spMk id="33" creationId="{68482F45-3E6A-0933-DA79-13495CB95827}"/>
          </ac:spMkLst>
        </pc:spChg>
        <pc:spChg chg="del mod">
          <ac:chgData name="Chamindi Seneviratne" userId="dccaeb4cfbf7da8e" providerId="LiveId" clId="{BBAF91B4-5F2A-497D-B562-74C214A90708}" dt="2023-12-21T04:28:44.024" v="477" actId="478"/>
          <ac:spMkLst>
            <pc:docMk/>
            <pc:sldMk cId="173754885" sldId="257"/>
            <ac:spMk id="34" creationId="{461CB627-1AFB-222E-AE01-8DB5B0343742}"/>
          </ac:spMkLst>
        </pc:spChg>
        <pc:spChg chg="del mod">
          <ac:chgData name="Chamindi Seneviratne" userId="dccaeb4cfbf7da8e" providerId="LiveId" clId="{BBAF91B4-5F2A-497D-B562-74C214A90708}" dt="2023-12-21T04:28:50.567" v="482" actId="478"/>
          <ac:spMkLst>
            <pc:docMk/>
            <pc:sldMk cId="173754885" sldId="257"/>
            <ac:spMk id="35" creationId="{E629AFAC-C954-0156-4FD1-67345B67BC0C}"/>
          </ac:spMkLst>
        </pc:spChg>
        <pc:spChg chg="del mod">
          <ac:chgData name="Chamindi Seneviratne" userId="dccaeb4cfbf7da8e" providerId="LiveId" clId="{BBAF91B4-5F2A-497D-B562-74C214A90708}" dt="2023-12-21T04:28:42.326" v="476" actId="478"/>
          <ac:spMkLst>
            <pc:docMk/>
            <pc:sldMk cId="173754885" sldId="257"/>
            <ac:spMk id="37" creationId="{FFA404F9-A34D-2656-08B8-D59EDDBAF09A}"/>
          </ac:spMkLst>
        </pc:spChg>
        <pc:spChg chg="del mod">
          <ac:chgData name="Chamindi Seneviratne" userId="dccaeb4cfbf7da8e" providerId="LiveId" clId="{BBAF91B4-5F2A-497D-B562-74C214A90708}" dt="2023-12-20T19:45:55.086" v="20" actId="478"/>
          <ac:spMkLst>
            <pc:docMk/>
            <pc:sldMk cId="173754885" sldId="257"/>
            <ac:spMk id="38" creationId="{023FE6D4-F3F2-5193-E6C5-5C4901D8A17F}"/>
          </ac:spMkLst>
        </pc:spChg>
        <pc:spChg chg="add del mod">
          <ac:chgData name="Chamindi Seneviratne" userId="dccaeb4cfbf7da8e" providerId="LiveId" clId="{BBAF91B4-5F2A-497D-B562-74C214A90708}" dt="2023-12-21T04:25:48.082" v="410" actId="478"/>
          <ac:spMkLst>
            <pc:docMk/>
            <pc:sldMk cId="173754885" sldId="257"/>
            <ac:spMk id="38" creationId="{2DB68F64-C96C-4043-F6BE-F85BBC587A71}"/>
          </ac:spMkLst>
        </pc:spChg>
        <pc:spChg chg="del mod ord">
          <ac:chgData name="Chamindi Seneviratne" userId="dccaeb4cfbf7da8e" providerId="LiveId" clId="{BBAF91B4-5F2A-497D-B562-74C214A90708}" dt="2023-12-21T04:28:47.334" v="479" actId="478"/>
          <ac:spMkLst>
            <pc:docMk/>
            <pc:sldMk cId="173754885" sldId="257"/>
            <ac:spMk id="39" creationId="{58CA9124-ECDB-9B06-D7BA-4FF9350E1789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41" creationId="{CE4477BA-9B31-57A5-E7A8-A971C9621D6F}"/>
          </ac:spMkLst>
        </pc:spChg>
        <pc:spChg chg="mod">
          <ac:chgData name="Chamindi Seneviratne" userId="dccaeb4cfbf7da8e" providerId="LiveId" clId="{BBAF91B4-5F2A-497D-B562-74C214A90708}" dt="2023-12-21T04:28:02.918" v="466" actId="20577"/>
          <ac:spMkLst>
            <pc:docMk/>
            <pc:sldMk cId="173754885" sldId="257"/>
            <ac:spMk id="42" creationId="{0E5A147E-4091-E841-36A7-E96B4629D625}"/>
          </ac:spMkLst>
        </pc:spChg>
        <pc:spChg chg="del mod">
          <ac:chgData name="Chamindi Seneviratne" userId="dccaeb4cfbf7da8e" providerId="LiveId" clId="{BBAF91B4-5F2A-497D-B562-74C214A90708}" dt="2023-12-21T04:26:18.294" v="426" actId="478"/>
          <ac:spMkLst>
            <pc:docMk/>
            <pc:sldMk cId="173754885" sldId="257"/>
            <ac:spMk id="44" creationId="{8F898CB8-9640-29B0-7BE2-4F44A53A8C26}"/>
          </ac:spMkLst>
        </pc:spChg>
        <pc:spChg chg="del mod">
          <ac:chgData name="Chamindi Seneviratne" userId="dccaeb4cfbf7da8e" providerId="LiveId" clId="{BBAF91B4-5F2A-497D-B562-74C214A90708}" dt="2023-12-21T04:26:08.455" v="421" actId="478"/>
          <ac:spMkLst>
            <pc:docMk/>
            <pc:sldMk cId="173754885" sldId="257"/>
            <ac:spMk id="45" creationId="{DB88A0DD-FA27-8350-EAF5-7407F4BCFDCE}"/>
          </ac:spMkLst>
        </pc:spChg>
        <pc:spChg chg="del mod">
          <ac:chgData name="Chamindi Seneviratne" userId="dccaeb4cfbf7da8e" providerId="LiveId" clId="{BBAF91B4-5F2A-497D-B562-74C214A90708}" dt="2023-12-21T04:26:28.827" v="432" actId="478"/>
          <ac:spMkLst>
            <pc:docMk/>
            <pc:sldMk cId="173754885" sldId="257"/>
            <ac:spMk id="46" creationId="{D1452831-2A5D-1868-52C5-4AC11BDB12B8}"/>
          </ac:spMkLst>
        </pc:spChg>
        <pc:spChg chg="del mod">
          <ac:chgData name="Chamindi Seneviratne" userId="dccaeb4cfbf7da8e" providerId="LiveId" clId="{BBAF91B4-5F2A-497D-B562-74C214A90708}" dt="2023-12-21T04:26:16.742" v="425" actId="478"/>
          <ac:spMkLst>
            <pc:docMk/>
            <pc:sldMk cId="173754885" sldId="257"/>
            <ac:spMk id="47" creationId="{00751FE9-3B8E-49FA-9E1B-81EC79DA195E}"/>
          </ac:spMkLst>
        </pc:spChg>
        <pc:spChg chg="del mod">
          <ac:chgData name="Chamindi Seneviratne" userId="dccaeb4cfbf7da8e" providerId="LiveId" clId="{BBAF91B4-5F2A-497D-B562-74C214A90708}" dt="2023-12-21T04:26:14.352" v="424" actId="478"/>
          <ac:spMkLst>
            <pc:docMk/>
            <pc:sldMk cId="173754885" sldId="257"/>
            <ac:spMk id="48" creationId="{6F1A81C8-DBCA-686D-BB05-256C519ECBBD}"/>
          </ac:spMkLst>
        </pc:spChg>
        <pc:spChg chg="del mod">
          <ac:chgData name="Chamindi Seneviratne" userId="dccaeb4cfbf7da8e" providerId="LiveId" clId="{BBAF91B4-5F2A-497D-B562-74C214A90708}" dt="2023-12-21T04:26:12.042" v="423" actId="478"/>
          <ac:spMkLst>
            <pc:docMk/>
            <pc:sldMk cId="173754885" sldId="257"/>
            <ac:spMk id="49" creationId="{E2B0C884-0A07-34B5-F293-42CF730FE5C2}"/>
          </ac:spMkLst>
        </pc:spChg>
        <pc:spChg chg="del mod">
          <ac:chgData name="Chamindi Seneviratne" userId="dccaeb4cfbf7da8e" providerId="LiveId" clId="{BBAF91B4-5F2A-497D-B562-74C214A90708}" dt="2023-12-21T04:26:25.597" v="430" actId="478"/>
          <ac:spMkLst>
            <pc:docMk/>
            <pc:sldMk cId="173754885" sldId="257"/>
            <ac:spMk id="50" creationId="{A21E13DA-87EC-8117-1943-58E42C4EC96D}"/>
          </ac:spMkLst>
        </pc:spChg>
        <pc:spChg chg="del mod">
          <ac:chgData name="Chamindi Seneviratne" userId="dccaeb4cfbf7da8e" providerId="LiveId" clId="{BBAF91B4-5F2A-497D-B562-74C214A90708}" dt="2023-12-21T04:26:27.061" v="431" actId="478"/>
          <ac:spMkLst>
            <pc:docMk/>
            <pc:sldMk cId="173754885" sldId="257"/>
            <ac:spMk id="51" creationId="{F8E54CA9-5B96-6ACA-7E98-FB256226567F}"/>
          </ac:spMkLst>
        </pc:spChg>
        <pc:spChg chg="del mod">
          <ac:chgData name="Chamindi Seneviratne" userId="dccaeb4cfbf7da8e" providerId="LiveId" clId="{BBAF91B4-5F2A-497D-B562-74C214A90708}" dt="2023-12-21T04:26:21.621" v="428" actId="478"/>
          <ac:spMkLst>
            <pc:docMk/>
            <pc:sldMk cId="173754885" sldId="257"/>
            <ac:spMk id="52" creationId="{F60D4577-29C8-3027-8A94-A5FDA70FFB62}"/>
          </ac:spMkLst>
        </pc:spChg>
        <pc:spChg chg="del mod">
          <ac:chgData name="Chamindi Seneviratne" userId="dccaeb4cfbf7da8e" providerId="LiveId" clId="{BBAF91B4-5F2A-497D-B562-74C214A90708}" dt="2023-12-21T04:26:23.521" v="429" actId="478"/>
          <ac:spMkLst>
            <pc:docMk/>
            <pc:sldMk cId="173754885" sldId="257"/>
            <ac:spMk id="53" creationId="{181EE32A-B93E-DF9D-2280-02663D284621}"/>
          </ac:spMkLst>
        </pc:spChg>
        <pc:spChg chg="del mod">
          <ac:chgData name="Chamindi Seneviratne" userId="dccaeb4cfbf7da8e" providerId="LiveId" clId="{BBAF91B4-5F2A-497D-B562-74C214A90708}" dt="2023-12-21T04:26:20.181" v="427" actId="478"/>
          <ac:spMkLst>
            <pc:docMk/>
            <pc:sldMk cId="173754885" sldId="257"/>
            <ac:spMk id="55" creationId="{2EA13E6F-4823-D8EF-1604-7A1E40463869}"/>
          </ac:spMkLst>
        </pc:spChg>
        <pc:spChg chg="del mod">
          <ac:chgData name="Chamindi Seneviratne" userId="dccaeb4cfbf7da8e" providerId="LiveId" clId="{BBAF91B4-5F2A-497D-B562-74C214A90708}" dt="2023-12-21T04:26:04.550" v="418" actId="478"/>
          <ac:spMkLst>
            <pc:docMk/>
            <pc:sldMk cId="173754885" sldId="257"/>
            <ac:spMk id="56" creationId="{190F22CD-C9F3-5910-FBFF-8436DCDA27B4}"/>
          </ac:spMkLst>
        </pc:spChg>
        <pc:spChg chg="del mod">
          <ac:chgData name="Chamindi Seneviratne" userId="dccaeb4cfbf7da8e" providerId="LiveId" clId="{BBAF91B4-5F2A-497D-B562-74C214A90708}" dt="2023-12-21T04:26:10.223" v="422" actId="478"/>
          <ac:spMkLst>
            <pc:docMk/>
            <pc:sldMk cId="173754885" sldId="257"/>
            <ac:spMk id="57" creationId="{DEFFAFE9-4F17-6978-A44F-425A2EB302BA}"/>
          </ac:spMkLst>
        </pc:spChg>
        <pc:spChg chg="add 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58" creationId="{6ADAA058-21FB-5EB1-EF36-5AB3F2057667}"/>
          </ac:spMkLst>
        </pc:spChg>
        <pc:spChg chg="add del mod">
          <ac:chgData name="Chamindi Seneviratne" userId="dccaeb4cfbf7da8e" providerId="LiveId" clId="{BBAF91B4-5F2A-497D-B562-74C214A90708}" dt="2023-12-21T04:28:40.542" v="475" actId="478"/>
          <ac:spMkLst>
            <pc:docMk/>
            <pc:sldMk cId="173754885" sldId="257"/>
            <ac:spMk id="59" creationId="{1927B42E-1114-83EE-CD50-CDA490B6799D}"/>
          </ac:spMkLst>
        </pc:spChg>
        <pc:spChg chg="add del mod">
          <ac:chgData name="Chamindi Seneviratne" userId="dccaeb4cfbf7da8e" providerId="LiveId" clId="{BBAF91B4-5F2A-497D-B562-74C214A90708}" dt="2023-12-20T19:45:57.820" v="21" actId="478"/>
          <ac:spMkLst>
            <pc:docMk/>
            <pc:sldMk cId="173754885" sldId="257"/>
            <ac:spMk id="60" creationId="{306AC1BB-EB1C-91E7-663D-9591E5D92141}"/>
          </ac:spMkLst>
        </pc:spChg>
        <pc:spChg chg="add del mod">
          <ac:chgData name="Chamindi Seneviratne" userId="dccaeb4cfbf7da8e" providerId="LiveId" clId="{BBAF91B4-5F2A-497D-B562-74C214A90708}" dt="2023-12-21T04:25:44.479" v="409" actId="478"/>
          <ac:spMkLst>
            <pc:docMk/>
            <pc:sldMk cId="173754885" sldId="257"/>
            <ac:spMk id="60" creationId="{8BD69F91-3A27-3B15-295C-FB1896E89AD7}"/>
          </ac:spMkLst>
        </pc:spChg>
        <pc:spChg chg="add del mod">
          <ac:chgData name="Chamindi Seneviratne" userId="dccaeb4cfbf7da8e" providerId="LiveId" clId="{BBAF91B4-5F2A-497D-B562-74C214A90708}" dt="2023-12-21T04:28:48.652" v="480" actId="478"/>
          <ac:spMkLst>
            <pc:docMk/>
            <pc:sldMk cId="173754885" sldId="257"/>
            <ac:spMk id="61" creationId="{082CED79-3471-C8C4-9C80-7368763476CD}"/>
          </ac:spMkLst>
        </pc:spChg>
        <pc:spChg chg="add 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62" creationId="{B21EE91C-2C92-5CBE-B6E8-13735D6D4C75}"/>
          </ac:spMkLst>
        </pc:spChg>
        <pc:spChg chg="add del mod">
          <ac:chgData name="Chamindi Seneviratne" userId="dccaeb4cfbf7da8e" providerId="LiveId" clId="{BBAF91B4-5F2A-497D-B562-74C214A90708}" dt="2023-12-21T04:28:38.592" v="474" actId="478"/>
          <ac:spMkLst>
            <pc:docMk/>
            <pc:sldMk cId="173754885" sldId="257"/>
            <ac:spMk id="63" creationId="{41796A61-4136-3A91-8148-4A8F5B2D95B7}"/>
          </ac:spMkLst>
        </pc:spChg>
        <pc:spChg chg="add del mod">
          <ac:chgData name="Chamindi Seneviratne" userId="dccaeb4cfbf7da8e" providerId="LiveId" clId="{BBAF91B4-5F2A-497D-B562-74C214A90708}" dt="2023-12-21T04:28:45.886" v="478" actId="478"/>
          <ac:spMkLst>
            <pc:docMk/>
            <pc:sldMk cId="173754885" sldId="257"/>
            <ac:spMk id="64" creationId="{85B5F708-70E0-F6C9-EDF3-DF3816A0CC1A}"/>
          </ac:spMkLst>
        </pc:spChg>
        <pc:spChg chg="add del mod">
          <ac:chgData name="Chamindi Seneviratne" userId="dccaeb4cfbf7da8e" providerId="LiveId" clId="{BBAF91B4-5F2A-497D-B562-74C214A90708}" dt="2023-12-21T04:29:00.046" v="488" actId="478"/>
          <ac:spMkLst>
            <pc:docMk/>
            <pc:sldMk cId="173754885" sldId="257"/>
            <ac:spMk id="65" creationId="{545F2079-06F7-F4FC-3CC3-12830B3593EB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67" creationId="{D6134577-5DD8-3B29-6A8C-FE6177A27424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68" creationId="{49A7E0F3-B0E0-E423-B440-0339669C4DD5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69" creationId="{7D3EC91B-07ED-0C9A-397A-5FBCEAC79EE1}"/>
          </ac:spMkLst>
        </pc:spChg>
        <pc:spChg chg="del mod">
          <ac:chgData name="Chamindi Seneviratne" userId="dccaeb4cfbf7da8e" providerId="LiveId" clId="{BBAF91B4-5F2A-497D-B562-74C214A90708}" dt="2023-12-20T20:01:08.353" v="232" actId="478"/>
          <ac:spMkLst>
            <pc:docMk/>
            <pc:sldMk cId="173754885" sldId="257"/>
            <ac:spMk id="69" creationId="{913508AB-E362-1B8B-EF15-C39176EA9254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70" creationId="{91F778CD-CFD4-4CFF-5025-AB07616E3D0D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71" creationId="{0C277135-EEE2-B3CF-699D-4A0ED6140608}"/>
          </ac:spMkLst>
        </pc:spChg>
        <pc:spChg chg="mod">
          <ac:chgData name="Chamindi Seneviratne" userId="dccaeb4cfbf7da8e" providerId="LiveId" clId="{BBAF91B4-5F2A-497D-B562-74C214A90708}" dt="2023-12-21T04:28:12.349" v="471" actId="20577"/>
          <ac:spMkLst>
            <pc:docMk/>
            <pc:sldMk cId="173754885" sldId="257"/>
            <ac:spMk id="72" creationId="{7F3C59CF-0EAC-51E0-3CBD-312A3B9D45E8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73" creationId="{C5ECF417-16D9-CA59-1A02-F7F59C11F46E}"/>
          </ac:spMkLst>
        </pc:spChg>
        <pc:spChg chg="mod">
          <ac:chgData name="Chamindi Seneviratne" userId="dccaeb4cfbf7da8e" providerId="LiveId" clId="{BBAF91B4-5F2A-497D-B562-74C214A90708}" dt="2023-12-21T04:39:31.714" v="575" actId="403"/>
          <ac:spMkLst>
            <pc:docMk/>
            <pc:sldMk cId="173754885" sldId="257"/>
            <ac:spMk id="74" creationId="{5B7D81C2-06C1-F72F-4E9F-929BE1D45083}"/>
          </ac:spMkLst>
        </pc:spChg>
        <pc:spChg chg="mod">
          <ac:chgData name="Chamindi Seneviratne" userId="dccaeb4cfbf7da8e" providerId="LiveId" clId="{BBAF91B4-5F2A-497D-B562-74C214A90708}" dt="2023-12-21T04:40:05.042" v="580" actId="403"/>
          <ac:spMkLst>
            <pc:docMk/>
            <pc:sldMk cId="173754885" sldId="257"/>
            <ac:spMk id="75" creationId="{002AC4BD-56DC-2615-C0B9-A0134EE512E6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76" creationId="{3FA5D3AF-9EC2-D3E7-86A2-63875266ADA8}"/>
          </ac:spMkLst>
        </pc:spChg>
        <pc:spChg chg="mod">
          <ac:chgData name="Chamindi Seneviratne" userId="dccaeb4cfbf7da8e" providerId="LiveId" clId="{BBAF91B4-5F2A-497D-B562-74C214A90708}" dt="2023-12-21T04:39:28.412" v="574" actId="403"/>
          <ac:spMkLst>
            <pc:docMk/>
            <pc:sldMk cId="173754885" sldId="257"/>
            <ac:spMk id="77" creationId="{FFB900B4-2232-6F20-848D-EC3F48986534}"/>
          </ac:spMkLst>
        </pc:spChg>
        <pc:spChg chg="mod">
          <ac:chgData name="Chamindi Seneviratne" userId="dccaeb4cfbf7da8e" providerId="LiveId" clId="{BBAF91B4-5F2A-497D-B562-74C214A90708}" dt="2023-12-21T04:40:12.080" v="582" actId="403"/>
          <ac:spMkLst>
            <pc:docMk/>
            <pc:sldMk cId="173754885" sldId="257"/>
            <ac:spMk id="78" creationId="{706134FA-8526-11AA-57F8-5847CCDAE310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79" creationId="{961FECE1-160F-9A98-BCB6-5C3ECF8A8702}"/>
          </ac:spMkLst>
        </pc:spChg>
        <pc:spChg chg="del mod">
          <ac:chgData name="Chamindi Seneviratne" userId="dccaeb4cfbf7da8e" providerId="LiveId" clId="{BBAF91B4-5F2A-497D-B562-74C214A90708}" dt="2023-12-20T20:00:53.447" v="228" actId="478"/>
          <ac:spMkLst>
            <pc:docMk/>
            <pc:sldMk cId="173754885" sldId="257"/>
            <ac:spMk id="80" creationId="{53544519-2C4C-F804-1129-F9B43E3DB475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80" creationId="{D44A5CDC-1CD0-BD97-6227-34D2152DE725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81" creationId="{384FBD2A-18C1-F92C-4D19-3B9480CD495C}"/>
          </ac:spMkLst>
        </pc:spChg>
        <pc:spChg chg="mod">
          <ac:chgData name="Chamindi Seneviratne" userId="dccaeb4cfbf7da8e" providerId="LiveId" clId="{BBAF91B4-5F2A-497D-B562-74C214A90708}" dt="2023-12-21T04:28:28.051" v="472" actId="6549"/>
          <ac:spMkLst>
            <pc:docMk/>
            <pc:sldMk cId="173754885" sldId="257"/>
            <ac:spMk id="83" creationId="{41B0C98F-0C41-46F3-2670-01B8F0E20A8B}"/>
          </ac:spMkLst>
        </pc:spChg>
        <pc:spChg chg="mod">
          <ac:chgData name="Chamindi Seneviratne" userId="dccaeb4cfbf7da8e" providerId="LiveId" clId="{BBAF91B4-5F2A-497D-B562-74C214A90708}" dt="2023-12-21T04:28:31.339" v="473" actId="6549"/>
          <ac:spMkLst>
            <pc:docMk/>
            <pc:sldMk cId="173754885" sldId="257"/>
            <ac:spMk id="84" creationId="{83203787-DDBB-9D42-DE94-59B320097ABF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85" creationId="{12BFD024-9C4D-1643-FF96-82DE77BB08F1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86" creationId="{0A038116-AB0D-0AAC-02FF-15A1363A7F0A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87" creationId="{4C450C76-D95B-1B9A-F562-F07B62C7D645}"/>
          </ac:spMkLst>
        </pc:spChg>
        <pc:spChg chg="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88" creationId="{E51151FE-FAE7-D86D-6A58-196E99D4B2DE}"/>
          </ac:spMkLst>
        </pc:spChg>
        <pc:spChg chg="mod">
          <ac:chgData name="Chamindi Seneviratne" userId="dccaeb4cfbf7da8e" providerId="LiveId" clId="{BBAF91B4-5F2A-497D-B562-74C214A90708}" dt="2023-12-21T04:39:59.582" v="578" actId="403"/>
          <ac:spMkLst>
            <pc:docMk/>
            <pc:sldMk cId="173754885" sldId="257"/>
            <ac:spMk id="89" creationId="{20A6D910-503F-D1FF-19B4-54F6C350C272}"/>
          </ac:spMkLst>
        </pc:spChg>
        <pc:spChg chg="mod">
          <ac:chgData name="Chamindi Seneviratne" userId="dccaeb4cfbf7da8e" providerId="LiveId" clId="{BBAF91B4-5F2A-497D-B562-74C214A90708}" dt="2023-12-21T04:39:56.478" v="577" actId="403"/>
          <ac:spMkLst>
            <pc:docMk/>
            <pc:sldMk cId="173754885" sldId="257"/>
            <ac:spMk id="90" creationId="{AD776B90-DDD8-313D-0F4A-1D76A7429B76}"/>
          </ac:spMkLst>
        </pc:spChg>
        <pc:spChg chg="mod">
          <ac:chgData name="Chamindi Seneviratne" userId="dccaeb4cfbf7da8e" providerId="LiveId" clId="{BBAF91B4-5F2A-497D-B562-74C214A90708}" dt="2023-12-21T04:39:50.246" v="576" actId="403"/>
          <ac:spMkLst>
            <pc:docMk/>
            <pc:sldMk cId="173754885" sldId="257"/>
            <ac:spMk id="91" creationId="{69656879-F14E-0FD0-936D-00D601F5A1CF}"/>
          </ac:spMkLst>
        </pc:spChg>
        <pc:spChg chg="add 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92" creationId="{57ECAFD7-3B02-F0A9-E0BD-DAB6A27F9984}"/>
          </ac:spMkLst>
        </pc:spChg>
        <pc:spChg chg="add 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93" creationId="{E4D7AD14-BEDF-D246-0DB0-AB64E45CDAF5}"/>
          </ac:spMkLst>
        </pc:spChg>
        <pc:spChg chg="add 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94" creationId="{5BFA2877-2D72-D0F7-CB12-F8CA7E1C4CEC}"/>
          </ac:spMkLst>
        </pc:spChg>
        <pc:spChg chg="add 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95" creationId="{4B7DFB64-50B3-E005-FA94-E4184C61706A}"/>
          </ac:spMkLst>
        </pc:spChg>
        <pc:spChg chg="add mod">
          <ac:chgData name="Chamindi Seneviratne" userId="dccaeb4cfbf7da8e" providerId="LiveId" clId="{BBAF91B4-5F2A-497D-B562-74C214A90708}" dt="2023-12-21T04:25:32.729" v="408" actId="571"/>
          <ac:spMkLst>
            <pc:docMk/>
            <pc:sldMk cId="173754885" sldId="257"/>
            <ac:spMk id="96" creationId="{E36962D4-3BC7-4231-0824-37EB93E02FFA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98" creationId="{6CB0ABA1-B8AD-B93B-3411-5E9F32CE9EBC}"/>
          </ac:spMkLst>
        </pc:spChg>
        <pc:spChg chg="add mod">
          <ac:chgData name="Chamindi Seneviratne" userId="dccaeb4cfbf7da8e" providerId="LiveId" clId="{BBAF91B4-5F2A-497D-B562-74C214A90708}" dt="2023-12-21T04:48:41.651" v="882" actId="20577"/>
          <ac:spMkLst>
            <pc:docMk/>
            <pc:sldMk cId="173754885" sldId="257"/>
            <ac:spMk id="99" creationId="{08FE84B9-C11B-07A1-E848-9BF1FE0E15D4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100" creationId="{6FEC12C2-8D62-D81A-5CE2-5613DB5075D5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101" creationId="{65DBE9AF-8153-B63F-AFF2-22A613869F49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102" creationId="{FC1D2A7F-01BB-7DE5-67B6-2A8FB2D736DA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103" creationId="{7C5754A7-61FA-16DB-4E9A-C892E5FD3FA7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104" creationId="{9DCF457F-262A-8D10-223A-61EFAE017126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105" creationId="{C54818DA-314E-6780-A6C3-90EDAAB8161A}"/>
          </ac:spMkLst>
        </pc:spChg>
        <pc:spChg chg="add mod">
          <ac:chgData name="Chamindi Seneviratne" userId="dccaeb4cfbf7da8e" providerId="LiveId" clId="{BBAF91B4-5F2A-497D-B562-74C214A90708}" dt="2023-12-21T04:31:18.725" v="527" actId="2711"/>
          <ac:spMkLst>
            <pc:docMk/>
            <pc:sldMk cId="173754885" sldId="257"/>
            <ac:spMk id="106" creationId="{542886CB-2C36-BBAC-1EC2-2D72426CDA83}"/>
          </ac:spMkLst>
        </pc:spChg>
        <pc:spChg chg="add mod">
          <ac:chgData name="Chamindi Seneviratne" userId="dccaeb4cfbf7da8e" providerId="LiveId" clId="{BBAF91B4-5F2A-497D-B562-74C214A90708}" dt="2023-12-21T04:49:08.757" v="883" actId="164"/>
          <ac:spMkLst>
            <pc:docMk/>
            <pc:sldMk cId="173754885" sldId="257"/>
            <ac:spMk id="108" creationId="{B3457A8C-F024-9791-FA82-B048DDE6E167}"/>
          </ac:spMkLst>
        </pc:spChg>
        <pc:spChg chg="add mod">
          <ac:chgData name="Chamindi Seneviratne" userId="dccaeb4cfbf7da8e" providerId="LiveId" clId="{BBAF91B4-5F2A-497D-B562-74C214A90708}" dt="2023-12-21T04:49:08.757" v="883" actId="164"/>
          <ac:spMkLst>
            <pc:docMk/>
            <pc:sldMk cId="173754885" sldId="257"/>
            <ac:spMk id="109" creationId="{45C6FBA5-8307-6F8A-7CB2-E9E82C053383}"/>
          </ac:spMkLst>
        </pc:spChg>
        <pc:spChg chg="add mod">
          <ac:chgData name="Chamindi Seneviratne" userId="dccaeb4cfbf7da8e" providerId="LiveId" clId="{BBAF91B4-5F2A-497D-B562-74C214A90708}" dt="2023-12-21T04:49:08.757" v="883" actId="164"/>
          <ac:spMkLst>
            <pc:docMk/>
            <pc:sldMk cId="173754885" sldId="257"/>
            <ac:spMk id="110" creationId="{3642EDD1-0115-9B5A-1F53-2109667BEEA9}"/>
          </ac:spMkLst>
        </pc:spChg>
        <pc:spChg chg="add mod">
          <ac:chgData name="Chamindi Seneviratne" userId="dccaeb4cfbf7da8e" providerId="LiveId" clId="{BBAF91B4-5F2A-497D-B562-74C214A90708}" dt="2023-12-21T04:33:29.081" v="558" actId="255"/>
          <ac:spMkLst>
            <pc:docMk/>
            <pc:sldMk cId="173754885" sldId="257"/>
            <ac:spMk id="111" creationId="{A5F79E3A-C8E8-9F77-3C5E-6A493E500A44}"/>
          </ac:spMkLst>
        </pc:spChg>
        <pc:spChg chg="add mod">
          <ac:chgData name="Chamindi Seneviratne" userId="dccaeb4cfbf7da8e" providerId="LiveId" clId="{BBAF91B4-5F2A-497D-B562-74C214A90708}" dt="2023-12-21T04:43:11.406" v="631" actId="207"/>
          <ac:spMkLst>
            <pc:docMk/>
            <pc:sldMk cId="173754885" sldId="257"/>
            <ac:spMk id="112" creationId="{F0575E6C-4865-6E33-8462-33A4BCE0DAAD}"/>
          </ac:spMkLst>
        </pc:spChg>
        <pc:spChg chg="add mod">
          <ac:chgData name="Chamindi Seneviratne" userId="dccaeb4cfbf7da8e" providerId="LiveId" clId="{BBAF91B4-5F2A-497D-B562-74C214A90708}" dt="2023-12-21T04:33:55.801" v="565" actId="1076"/>
          <ac:spMkLst>
            <pc:docMk/>
            <pc:sldMk cId="173754885" sldId="257"/>
            <ac:spMk id="113" creationId="{9CD113C1-9FE1-0D67-1BDA-25057C574976}"/>
          </ac:spMkLst>
        </pc:spChg>
        <pc:spChg chg="add mod">
          <ac:chgData name="Chamindi Seneviratne" userId="dccaeb4cfbf7da8e" providerId="LiveId" clId="{BBAF91B4-5F2A-497D-B562-74C214A90708}" dt="2023-12-21T04:34:12.864" v="569" actId="404"/>
          <ac:spMkLst>
            <pc:docMk/>
            <pc:sldMk cId="173754885" sldId="257"/>
            <ac:spMk id="114" creationId="{41F2A1C7-9531-2D17-6BE9-564E47B2A808}"/>
          </ac:spMkLst>
        </pc:spChg>
        <pc:spChg chg="add mod">
          <ac:chgData name="Chamindi Seneviratne" userId="dccaeb4cfbf7da8e" providerId="LiveId" clId="{BBAF91B4-5F2A-497D-B562-74C214A90708}" dt="2023-12-21T04:33:29.081" v="558" actId="255"/>
          <ac:spMkLst>
            <pc:docMk/>
            <pc:sldMk cId="173754885" sldId="257"/>
            <ac:spMk id="115" creationId="{9DC0DF63-D546-FED6-F31F-E91F5F30F39D}"/>
          </ac:spMkLst>
        </pc:spChg>
        <pc:spChg chg="add mod">
          <ac:chgData name="Chamindi Seneviratne" userId="dccaeb4cfbf7da8e" providerId="LiveId" clId="{BBAF91B4-5F2A-497D-B562-74C214A90708}" dt="2023-12-21T04:34:18.391" v="571" actId="404"/>
          <ac:spMkLst>
            <pc:docMk/>
            <pc:sldMk cId="173754885" sldId="257"/>
            <ac:spMk id="116" creationId="{B1DBF29A-3DB7-E21B-03B5-3A30B9A2DB6D}"/>
          </ac:spMkLst>
        </pc:spChg>
        <pc:spChg chg="add mod">
          <ac:chgData name="Chamindi Seneviratne" userId="dccaeb4cfbf7da8e" providerId="LiveId" clId="{BBAF91B4-5F2A-497D-B562-74C214A90708}" dt="2023-12-21T04:34:15.797" v="570" actId="404"/>
          <ac:spMkLst>
            <pc:docMk/>
            <pc:sldMk cId="173754885" sldId="257"/>
            <ac:spMk id="117" creationId="{31C361CC-5168-325F-FFFB-132A241B4768}"/>
          </ac:spMkLst>
        </pc:spChg>
        <pc:spChg chg="add mod">
          <ac:chgData name="Chamindi Seneviratne" userId="dccaeb4cfbf7da8e" providerId="LiveId" clId="{BBAF91B4-5F2A-497D-B562-74C214A90708}" dt="2023-12-21T04:33:48.917" v="563" actId="1076"/>
          <ac:spMkLst>
            <pc:docMk/>
            <pc:sldMk cId="173754885" sldId="257"/>
            <ac:spMk id="118" creationId="{BEAF4968-481E-7F23-BA9F-F27C0766660A}"/>
          </ac:spMkLst>
        </pc:spChg>
        <pc:spChg chg="add mod">
          <ac:chgData name="Chamindi Seneviratne" userId="dccaeb4cfbf7da8e" providerId="LiveId" clId="{BBAF91B4-5F2A-497D-B562-74C214A90708}" dt="2023-12-21T04:33:52.741" v="564" actId="1076"/>
          <ac:spMkLst>
            <pc:docMk/>
            <pc:sldMk cId="173754885" sldId="257"/>
            <ac:spMk id="119" creationId="{49871E95-BD10-033D-B69D-02A27EF21EC0}"/>
          </ac:spMkLst>
        </pc:spChg>
        <pc:spChg chg="add mod">
          <ac:chgData name="Chamindi Seneviratne" userId="dccaeb4cfbf7da8e" providerId="LiveId" clId="{BBAF91B4-5F2A-497D-B562-74C214A90708}" dt="2023-12-21T04:34:01.229" v="566" actId="1076"/>
          <ac:spMkLst>
            <pc:docMk/>
            <pc:sldMk cId="173754885" sldId="257"/>
            <ac:spMk id="120" creationId="{0A158B49-E79F-F76C-E878-4797917005D9}"/>
          </ac:spMkLst>
        </pc:spChg>
        <pc:spChg chg="add mod">
          <ac:chgData name="Chamindi Seneviratne" userId="dccaeb4cfbf7da8e" providerId="LiveId" clId="{BBAF91B4-5F2A-497D-B562-74C214A90708}" dt="2023-12-21T04:34:08.679" v="568" actId="1076"/>
          <ac:spMkLst>
            <pc:docMk/>
            <pc:sldMk cId="173754885" sldId="257"/>
            <ac:spMk id="121" creationId="{9E3FE585-9D0C-1FBF-992B-08C2CBA910BC}"/>
          </ac:spMkLst>
        </pc:spChg>
        <pc:spChg chg="add mod">
          <ac:chgData name="Chamindi Seneviratne" userId="dccaeb4cfbf7da8e" providerId="LiveId" clId="{BBAF91B4-5F2A-497D-B562-74C214A90708}" dt="2023-12-21T04:33:46.557" v="562" actId="1076"/>
          <ac:spMkLst>
            <pc:docMk/>
            <pc:sldMk cId="173754885" sldId="257"/>
            <ac:spMk id="122" creationId="{8E829B42-712A-B58C-AF9F-233C534208E1}"/>
          </ac:spMkLst>
        </pc:spChg>
        <pc:spChg chg="add mod">
          <ac:chgData name="Chamindi Seneviratne" userId="dccaeb4cfbf7da8e" providerId="LiveId" clId="{BBAF91B4-5F2A-497D-B562-74C214A90708}" dt="2023-12-21T04:34:04.637" v="567" actId="1076"/>
          <ac:spMkLst>
            <pc:docMk/>
            <pc:sldMk cId="173754885" sldId="257"/>
            <ac:spMk id="123" creationId="{C738E0C2-F161-D995-54AB-0595E62148CF}"/>
          </ac:spMkLst>
        </pc:spChg>
        <pc:spChg chg="add mod">
          <ac:chgData name="Chamindi Seneviratne" userId="dccaeb4cfbf7da8e" providerId="LiveId" clId="{BBAF91B4-5F2A-497D-B562-74C214A90708}" dt="2023-12-21T04:41:25.122" v="588" actId="403"/>
          <ac:spMkLst>
            <pc:docMk/>
            <pc:sldMk cId="173754885" sldId="257"/>
            <ac:spMk id="125" creationId="{D1A42050-8AE0-CD79-C420-B5E351AF4699}"/>
          </ac:spMkLst>
        </pc:spChg>
        <pc:spChg chg="add mod">
          <ac:chgData name="Chamindi Seneviratne" userId="dccaeb4cfbf7da8e" providerId="LiveId" clId="{BBAF91B4-5F2A-497D-B562-74C214A90708}" dt="2023-12-21T04:43:08.315" v="630" actId="207"/>
          <ac:spMkLst>
            <pc:docMk/>
            <pc:sldMk cId="173754885" sldId="257"/>
            <ac:spMk id="126" creationId="{BF77737B-2810-3E8A-66E9-8D95542FCE18}"/>
          </ac:spMkLst>
        </pc:spChg>
        <pc:spChg chg="add mod">
          <ac:chgData name="Chamindi Seneviratne" userId="dccaeb4cfbf7da8e" providerId="LiveId" clId="{BBAF91B4-5F2A-497D-B562-74C214A90708}" dt="2023-12-21T04:41:32.606" v="589" actId="1076"/>
          <ac:spMkLst>
            <pc:docMk/>
            <pc:sldMk cId="173754885" sldId="257"/>
            <ac:spMk id="127" creationId="{2DC7C13A-B8FD-40E5-903D-2E407E1478AB}"/>
          </ac:spMkLst>
        </pc:spChg>
        <pc:spChg chg="add mod">
          <ac:chgData name="Chamindi Seneviratne" userId="dccaeb4cfbf7da8e" providerId="LiveId" clId="{BBAF91B4-5F2A-497D-B562-74C214A90708}" dt="2023-12-21T04:41:45.540" v="602" actId="20577"/>
          <ac:spMkLst>
            <pc:docMk/>
            <pc:sldMk cId="173754885" sldId="257"/>
            <ac:spMk id="128" creationId="{E07E0E84-F20D-7C0A-B125-0C97A7E20FAD}"/>
          </ac:spMkLst>
        </pc:spChg>
        <pc:spChg chg="add mod">
          <ac:chgData name="Chamindi Seneviratne" userId="dccaeb4cfbf7da8e" providerId="LiveId" clId="{BBAF91B4-5F2A-497D-B562-74C214A90708}" dt="2023-12-21T04:41:25.122" v="588" actId="403"/>
          <ac:spMkLst>
            <pc:docMk/>
            <pc:sldMk cId="173754885" sldId="257"/>
            <ac:spMk id="129" creationId="{C46B4413-CFF7-897F-DD8E-DD3FA72DAE3E}"/>
          </ac:spMkLst>
        </pc:spChg>
        <pc:spChg chg="add mod">
          <ac:chgData name="Chamindi Seneviratne" userId="dccaeb4cfbf7da8e" providerId="LiveId" clId="{BBAF91B4-5F2A-497D-B562-74C214A90708}" dt="2023-12-21T04:42:11.028" v="614" actId="404"/>
          <ac:spMkLst>
            <pc:docMk/>
            <pc:sldMk cId="173754885" sldId="257"/>
            <ac:spMk id="130" creationId="{66C8D87D-3D63-9ED9-3C74-1F1D5A5B2A07}"/>
          </ac:spMkLst>
        </pc:spChg>
        <pc:spChg chg="add mod">
          <ac:chgData name="Chamindi Seneviratne" userId="dccaeb4cfbf7da8e" providerId="LiveId" clId="{BBAF91B4-5F2A-497D-B562-74C214A90708}" dt="2023-12-21T04:42:35.589" v="621" actId="1076"/>
          <ac:spMkLst>
            <pc:docMk/>
            <pc:sldMk cId="173754885" sldId="257"/>
            <ac:spMk id="131" creationId="{BAD14AE2-68DC-E93C-A6F1-E9EC0A1D4EEB}"/>
          </ac:spMkLst>
        </pc:spChg>
        <pc:spChg chg="add mod">
          <ac:chgData name="Chamindi Seneviratne" userId="dccaeb4cfbf7da8e" providerId="LiveId" clId="{BBAF91B4-5F2A-497D-B562-74C214A90708}" dt="2023-12-21T04:43:05.566" v="629" actId="1076"/>
          <ac:spMkLst>
            <pc:docMk/>
            <pc:sldMk cId="173754885" sldId="257"/>
            <ac:spMk id="132" creationId="{5CB5753B-7BEB-C33E-CE4B-4C6E64B821C3}"/>
          </ac:spMkLst>
        </pc:spChg>
        <pc:spChg chg="add mod">
          <ac:chgData name="Chamindi Seneviratne" userId="dccaeb4cfbf7da8e" providerId="LiveId" clId="{BBAF91B4-5F2A-497D-B562-74C214A90708}" dt="2023-12-21T04:42:53.737" v="626" actId="1076"/>
          <ac:spMkLst>
            <pc:docMk/>
            <pc:sldMk cId="173754885" sldId="257"/>
            <ac:spMk id="133" creationId="{B1191C7A-91D3-1916-77B0-35E34E31E6A3}"/>
          </ac:spMkLst>
        </pc:spChg>
        <pc:spChg chg="add mod">
          <ac:chgData name="Chamindi Seneviratne" userId="dccaeb4cfbf7da8e" providerId="LiveId" clId="{BBAF91B4-5F2A-497D-B562-74C214A90708}" dt="2023-12-21T04:42:14.523" v="615" actId="1076"/>
          <ac:spMkLst>
            <pc:docMk/>
            <pc:sldMk cId="173754885" sldId="257"/>
            <ac:spMk id="134" creationId="{19B4F15E-7584-57D6-C57E-30DED12203A6}"/>
          </ac:spMkLst>
        </pc:spChg>
        <pc:spChg chg="add mod">
          <ac:chgData name="Chamindi Seneviratne" userId="dccaeb4cfbf7da8e" providerId="LiveId" clId="{BBAF91B4-5F2A-497D-B562-74C214A90708}" dt="2023-12-21T04:42:44.809" v="624" actId="1076"/>
          <ac:spMkLst>
            <pc:docMk/>
            <pc:sldMk cId="173754885" sldId="257"/>
            <ac:spMk id="135" creationId="{B5A02540-9A2C-FCB4-15A5-BDB30763375C}"/>
          </ac:spMkLst>
        </pc:spChg>
        <pc:spChg chg="add mod">
          <ac:chgData name="Chamindi Seneviratne" userId="dccaeb4cfbf7da8e" providerId="LiveId" clId="{BBAF91B4-5F2A-497D-B562-74C214A90708}" dt="2023-12-21T04:42:22.760" v="618" actId="20577"/>
          <ac:spMkLst>
            <pc:docMk/>
            <pc:sldMk cId="173754885" sldId="257"/>
            <ac:spMk id="136" creationId="{6D294271-C610-D424-9372-C73652667470}"/>
          </ac:spMkLst>
        </pc:spChg>
        <pc:spChg chg="add mod">
          <ac:chgData name="Chamindi Seneviratne" userId="dccaeb4cfbf7da8e" providerId="LiveId" clId="{BBAF91B4-5F2A-497D-B562-74C214A90708}" dt="2023-12-21T04:49:08.757" v="883" actId="164"/>
          <ac:spMkLst>
            <pc:docMk/>
            <pc:sldMk cId="173754885" sldId="257"/>
            <ac:spMk id="138" creationId="{DB7B10E2-1876-8202-0E96-475A0B047408}"/>
          </ac:spMkLst>
        </pc:spChg>
        <pc:grpChg chg="add mod">
          <ac:chgData name="Chamindi Seneviratne" userId="dccaeb4cfbf7da8e" providerId="LiveId" clId="{BBAF91B4-5F2A-497D-B562-74C214A90708}" dt="2023-12-21T04:25:32.729" v="408" actId="571"/>
          <ac:grpSpMkLst>
            <pc:docMk/>
            <pc:sldMk cId="173754885" sldId="257"/>
            <ac:grpSpMk id="2" creationId="{0E153D6E-2439-49C9-D2D9-2DD3C233B61E}"/>
          </ac:grpSpMkLst>
        </pc:grpChg>
        <pc:grpChg chg="mod">
          <ac:chgData name="Chamindi Seneviratne" userId="dccaeb4cfbf7da8e" providerId="LiveId" clId="{BBAF91B4-5F2A-497D-B562-74C214A90708}" dt="2023-12-21T04:25:32.729" v="408" actId="571"/>
          <ac:grpSpMkLst>
            <pc:docMk/>
            <pc:sldMk cId="173754885" sldId="257"/>
            <ac:grpSpMk id="3" creationId="{D1A61C12-ACA0-8D19-28BF-22ABA93D671D}"/>
          </ac:grpSpMkLst>
        </pc:grpChg>
        <pc:grpChg chg="mod">
          <ac:chgData name="Chamindi Seneviratne" userId="dccaeb4cfbf7da8e" providerId="LiveId" clId="{BBAF91B4-5F2A-497D-B562-74C214A90708}" dt="2023-12-21T04:25:32.729" v="408" actId="571"/>
          <ac:grpSpMkLst>
            <pc:docMk/>
            <pc:sldMk cId="173754885" sldId="257"/>
            <ac:grpSpMk id="4" creationId="{385C9369-C152-35AB-3320-511C0CEB15EA}"/>
          </ac:grpSpMkLst>
        </pc:grpChg>
        <pc:grpChg chg="mod">
          <ac:chgData name="Chamindi Seneviratne" userId="dccaeb4cfbf7da8e" providerId="LiveId" clId="{BBAF91B4-5F2A-497D-B562-74C214A90708}" dt="2023-12-21T04:25:32.729" v="408" actId="571"/>
          <ac:grpSpMkLst>
            <pc:docMk/>
            <pc:sldMk cId="173754885" sldId="257"/>
            <ac:grpSpMk id="6" creationId="{F641232F-D8D7-125D-6ED6-715DB9552EC5}"/>
          </ac:grpSpMkLst>
        </pc:grpChg>
        <pc:grpChg chg="del mod">
          <ac:chgData name="Chamindi Seneviratne" userId="dccaeb4cfbf7da8e" providerId="LiveId" clId="{BBAF91B4-5F2A-497D-B562-74C214A90708}" dt="2023-12-21T04:26:00.870" v="417" actId="478"/>
          <ac:grpSpMkLst>
            <pc:docMk/>
            <pc:sldMk cId="173754885" sldId="257"/>
            <ac:grpSpMk id="7" creationId="{1A92E3DB-3A82-15FD-A87F-E95A5FF10D34}"/>
          </ac:grpSpMkLst>
        </pc:grpChg>
        <pc:grpChg chg="del mod">
          <ac:chgData name="Chamindi Seneviratne" userId="dccaeb4cfbf7da8e" providerId="LiveId" clId="{BBAF91B4-5F2A-497D-B562-74C214A90708}" dt="2023-12-21T04:25:56.040" v="414" actId="478"/>
          <ac:grpSpMkLst>
            <pc:docMk/>
            <pc:sldMk cId="173754885" sldId="257"/>
            <ac:grpSpMk id="10" creationId="{4E9BC97A-20FF-E542-FE69-59C245EDFC18}"/>
          </ac:grpSpMkLst>
        </pc:grpChg>
        <pc:grpChg chg="del mod">
          <ac:chgData name="Chamindi Seneviratne" userId="dccaeb4cfbf7da8e" providerId="LiveId" clId="{BBAF91B4-5F2A-497D-B562-74C214A90708}" dt="2023-12-21T04:25:49.927" v="411" actId="478"/>
          <ac:grpSpMkLst>
            <pc:docMk/>
            <pc:sldMk cId="173754885" sldId="257"/>
            <ac:grpSpMk id="21" creationId="{53E816EF-B091-1280-C6F2-4A3CB994FC0B}"/>
          </ac:grpSpMkLst>
        </pc:grpChg>
        <pc:grpChg chg="del mod">
          <ac:chgData name="Chamindi Seneviratne" userId="dccaeb4cfbf7da8e" providerId="LiveId" clId="{BBAF91B4-5F2A-497D-B562-74C214A90708}" dt="2023-12-21T04:28:57.436" v="486" actId="478"/>
          <ac:grpSpMkLst>
            <pc:docMk/>
            <pc:sldMk cId="173754885" sldId="257"/>
            <ac:grpSpMk id="27" creationId="{D09BEC6D-5876-A1BD-41E7-AAA859EB1EB5}"/>
          </ac:grpSpMkLst>
        </pc:grpChg>
        <pc:grpChg chg="del mod">
          <ac:chgData name="Chamindi Seneviratne" userId="dccaeb4cfbf7da8e" providerId="LiveId" clId="{BBAF91B4-5F2A-497D-B562-74C214A90708}" dt="2023-12-21T04:28:42.326" v="476" actId="478"/>
          <ac:grpSpMkLst>
            <pc:docMk/>
            <pc:sldMk cId="173754885" sldId="257"/>
            <ac:grpSpMk id="28" creationId="{A4AEA028-6C49-C1A8-537E-DB1ABDCB3528}"/>
          </ac:grpSpMkLst>
        </pc:grpChg>
        <pc:grpChg chg="del mod">
          <ac:chgData name="Chamindi Seneviratne" userId="dccaeb4cfbf7da8e" providerId="LiveId" clId="{BBAF91B4-5F2A-497D-B562-74C214A90708}" dt="2023-12-21T04:28:40.542" v="475" actId="478"/>
          <ac:grpSpMkLst>
            <pc:docMk/>
            <pc:sldMk cId="173754885" sldId="257"/>
            <ac:grpSpMk id="36" creationId="{BB3C0244-6404-98F9-5681-890BF00231AD}"/>
          </ac:grpSpMkLst>
        </pc:grpChg>
        <pc:grpChg chg="del mod">
          <ac:chgData name="Chamindi Seneviratne" userId="dccaeb4cfbf7da8e" providerId="LiveId" clId="{BBAF91B4-5F2A-497D-B562-74C214A90708}" dt="2023-12-21T04:26:27.061" v="431" actId="478"/>
          <ac:grpSpMkLst>
            <pc:docMk/>
            <pc:sldMk cId="173754885" sldId="257"/>
            <ac:grpSpMk id="40" creationId="{C40DA0B9-1B91-D4D7-9AE5-A5DF6B341D08}"/>
          </ac:grpSpMkLst>
        </pc:grpChg>
        <pc:grpChg chg="del mod">
          <ac:chgData name="Chamindi Seneviratne" userId="dccaeb4cfbf7da8e" providerId="LiveId" clId="{BBAF91B4-5F2A-497D-B562-74C214A90708}" dt="2023-12-21T04:26:10.223" v="422" actId="478"/>
          <ac:grpSpMkLst>
            <pc:docMk/>
            <pc:sldMk cId="173754885" sldId="257"/>
            <ac:grpSpMk id="43" creationId="{92DA14BE-A86B-494F-02A9-F7322556963C}"/>
          </ac:grpSpMkLst>
        </pc:grpChg>
        <pc:grpChg chg="del mod">
          <ac:chgData name="Chamindi Seneviratne" userId="dccaeb4cfbf7da8e" providerId="LiveId" clId="{BBAF91B4-5F2A-497D-B562-74C214A90708}" dt="2023-12-21T04:26:04.550" v="418" actId="478"/>
          <ac:grpSpMkLst>
            <pc:docMk/>
            <pc:sldMk cId="173754885" sldId="257"/>
            <ac:grpSpMk id="54" creationId="{B637F4A7-E4CC-5B1D-8D61-921FEB545E66}"/>
          </ac:grpSpMkLst>
        </pc:grpChg>
        <pc:grpChg chg="add mod">
          <ac:chgData name="Chamindi Seneviratne" userId="dccaeb4cfbf7da8e" providerId="LiveId" clId="{BBAF91B4-5F2A-497D-B562-74C214A90708}" dt="2023-12-21T04:25:32.729" v="408" actId="571"/>
          <ac:grpSpMkLst>
            <pc:docMk/>
            <pc:sldMk cId="173754885" sldId="257"/>
            <ac:grpSpMk id="66" creationId="{335A40D8-0EE4-00B6-8568-C7E79DAF1918}"/>
          </ac:grpSpMkLst>
        </pc:grpChg>
        <pc:grpChg chg="mod">
          <ac:chgData name="Chamindi Seneviratne" userId="dccaeb4cfbf7da8e" providerId="LiveId" clId="{BBAF91B4-5F2A-497D-B562-74C214A90708}" dt="2023-12-21T04:25:32.729" v="408" actId="571"/>
          <ac:grpSpMkLst>
            <pc:docMk/>
            <pc:sldMk cId="173754885" sldId="257"/>
            <ac:grpSpMk id="82" creationId="{2B53A1A8-1579-0C1A-4D05-9963103DEBAD}"/>
          </ac:grpSpMkLst>
        </pc:grpChg>
        <pc:grpChg chg="add del mod">
          <ac:chgData name="Chamindi Seneviratne" userId="dccaeb4cfbf7da8e" providerId="LiveId" clId="{BBAF91B4-5F2A-497D-B562-74C214A90708}" dt="2023-12-21T04:49:08.757" v="883" actId="164"/>
          <ac:grpSpMkLst>
            <pc:docMk/>
            <pc:sldMk cId="173754885" sldId="257"/>
            <ac:grpSpMk id="97" creationId="{9320148F-DBAF-7A54-53A9-973158BCEB90}"/>
          </ac:grpSpMkLst>
        </pc:grpChg>
        <pc:grpChg chg="add mod">
          <ac:chgData name="Chamindi Seneviratne" userId="dccaeb4cfbf7da8e" providerId="LiveId" clId="{BBAF91B4-5F2A-497D-B562-74C214A90708}" dt="2023-12-21T04:49:08.757" v="883" actId="164"/>
          <ac:grpSpMkLst>
            <pc:docMk/>
            <pc:sldMk cId="173754885" sldId="257"/>
            <ac:grpSpMk id="107" creationId="{6909E77C-9339-BD89-9D0E-7FAF585DAD10}"/>
          </ac:grpSpMkLst>
        </pc:grpChg>
        <pc:grpChg chg="add mod">
          <ac:chgData name="Chamindi Seneviratne" userId="dccaeb4cfbf7da8e" providerId="LiveId" clId="{BBAF91B4-5F2A-497D-B562-74C214A90708}" dt="2023-12-21T04:49:08.757" v="883" actId="164"/>
          <ac:grpSpMkLst>
            <pc:docMk/>
            <pc:sldMk cId="173754885" sldId="257"/>
            <ac:grpSpMk id="124" creationId="{5380FFF1-A92A-704A-AD00-2D1B4B8AD67A}"/>
          </ac:grpSpMkLst>
        </pc:grpChg>
        <pc:grpChg chg="add mod">
          <ac:chgData name="Chamindi Seneviratne" userId="dccaeb4cfbf7da8e" providerId="LiveId" clId="{BBAF91B4-5F2A-497D-B562-74C214A90708}" dt="2023-12-21T04:49:08.757" v="883" actId="164"/>
          <ac:grpSpMkLst>
            <pc:docMk/>
            <pc:sldMk cId="173754885" sldId="257"/>
            <ac:grpSpMk id="137" creationId="{FE1DC158-C2D1-068E-7ABD-5ACCBBBC2BA6}"/>
          </ac:grpSpMkLst>
        </pc:grpChg>
        <pc:grpChg chg="add mod">
          <ac:chgData name="Chamindi Seneviratne" userId="dccaeb4cfbf7da8e" providerId="LiveId" clId="{BBAF91B4-5F2A-497D-B562-74C214A90708}" dt="2023-12-21T04:49:12.476" v="884" actId="1076"/>
          <ac:grpSpMkLst>
            <pc:docMk/>
            <pc:sldMk cId="173754885" sldId="257"/>
            <ac:grpSpMk id="139" creationId="{C5B8E98E-A268-758F-30C9-D8BA381D504C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CBC51E-EC19-0E65-344A-F1D0DC5C14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2439CDA-D1DF-DA50-2D5C-460E929DB1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88958F-8639-8FD2-FAB4-133B7B23B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8DD36D-61F5-68D6-A29E-15DE33775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829D36-17EA-A602-502A-FC322AC37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772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863FA-04FE-4D80-C3D9-CF343A8B14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AF0DD0-F9A3-B068-C107-79CCECBA86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E32CC6-6321-370F-6970-F6721FC38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E68B0A-B64C-5684-01E4-F58DFBB0F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FDA967-D1B8-AEE7-74D6-CF242805A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342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83BD965-473D-1A4E-5CE2-871ED5C663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CC848A-2218-E7EA-879E-E97DD9638A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83C9D7-0FF6-B96A-4350-C3B8BAD8F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221AF-F537-5676-54DD-53732A402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9F1C90-BE2E-D793-8CD0-4D0F99323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058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0DECAC-DC92-A7CC-35B0-CEDFC22EF7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86C7BB-1DBA-0268-748C-A88F1683CF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89E9F8-4AEC-FD8E-D24A-06D1774C1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8BA376-FD3F-1DAE-ED23-0EAEA0E7E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4728F6-C520-8796-51AF-8535E645D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642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BDDD4A-4100-1084-0605-A4844A9E6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A22D11-DC62-509D-257A-8F27F556F5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0C9B5F-1B99-E400-2692-3FF8780D5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A180E-B150-568B-69D1-8E341C5A0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D29331-B9E6-297C-D521-524088DBF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288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EB0B5-FA6C-E057-D14F-D872C08056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97938E-0EAE-F343-90BC-B9237F4FB4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F56049-9FC1-4736-4676-DE97DD618A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963E47-2924-D33F-5F60-2FDBBC0DA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E1A1C5-78EB-6EFC-C399-5B0937C52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553067-C38B-DE67-7290-A0BCC2304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257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0803A7-CD3D-515E-0547-ACF654AB02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0AE5B5-8ADB-9393-7416-F82FA3EFE2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E94833-2E03-FBA6-E6B7-F97C5E4774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1385155-C089-9C85-4117-5C7DDF1190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337ED76-1C4C-1AB0-CE30-D5989B1D68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84CECF-36AC-E793-0337-382E58FF4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E6604F-88E0-8708-CBFC-6C1104FA9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6D1C09E-A008-682D-CBD2-0EB4FCCE8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721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F683A7-DA06-F9EC-AA2D-3D4D80B88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2D618A7-DACA-0A94-E77B-845F6E43F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2FF28A-89DC-89C3-CF4E-B11CFC49E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8CC1B4-FCA1-767A-53F5-B3880C22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81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349DFE6-0CE7-0BC2-2B83-8821DD7BB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FCC283-418D-D661-43F3-A22137C4B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578840A-A7D0-79D1-EDDA-9C22D6C11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127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E3FC5-1345-F1B1-22F3-27F75F77A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203067-F5F6-4F06-837D-3B2DCCC9F5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B5AF2A-C88A-97D0-586C-0D907891BD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BA2975-59C0-230F-4E25-BB89F4282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051211-3968-760B-55D0-B5D23BDBB8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E4C075-D495-F244-154C-7A890C891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492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562C6-EABE-814D-36D4-0E5D138DCC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261D527-C583-2D6D-10C1-807C6108EC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B55C9C-85E7-10E2-09D8-035524DE41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0324F1-99ED-0152-C633-2E21E626E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47CBB8-FEC1-4337-9477-D814AB2AE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14D93E-8F8A-4439-13E1-341202AFA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617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9BC3E4-B254-4C06-FDCF-50362DD97B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D805DD-4DB4-7CC4-007A-078E7B876A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E4B98D-8B0A-AA6E-DC37-BC6CDF2FAC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215B22-EA7D-4F1E-9D4C-7CA811163C38}" type="datetimeFigureOut">
              <a:rPr lang="en-US" smtClean="0"/>
              <a:t>1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942226-A883-F41F-7371-30817674B7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50BDC6-6ABA-604D-3CB2-37E55DDCA2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942875-650C-49D7-A59E-5FA2B96BD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410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Box 98">
            <a:extLst>
              <a:ext uri="{FF2B5EF4-FFF2-40B4-BE49-F238E27FC236}">
                <a16:creationId xmlns:a16="http://schemas.microsoft.com/office/drawing/2014/main" id="{08FE84B9-C11B-07A1-E848-9BF1FE0E15D4}"/>
              </a:ext>
            </a:extLst>
          </p:cNvPr>
          <p:cNvSpPr txBox="1"/>
          <p:nvPr/>
        </p:nvSpPr>
        <p:spPr>
          <a:xfrm>
            <a:off x="8935928" y="306825"/>
            <a:ext cx="2920807" cy="47681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S1: DEGs across experiments in response to beverage doses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tected with RNA-seq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mbers outside parentheses represent the numbers of significant DEGs (p&lt;0.05) before FDR adjustments. Numbers within parentheses represent DEGs that remained significant after adjustments for FDR.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s A-C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llustrate the numbers of DEGs detected within each experimental sequence in response to the three </a:t>
            </a:r>
            <a:r>
              <a:rPr lang="en-US" sz="12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ses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parately. 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s D-F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llustrate the distribution of DEGs detected within each experimental sequence when responses to placebo were subtracted from the alcohol doses (i.e., binge or medium) assigned to an experiment.</a:t>
            </a:r>
          </a:p>
        </p:txBody>
      </p:sp>
      <p:grpSp>
        <p:nvGrpSpPr>
          <p:cNvPr id="139" name="Group 138">
            <a:extLst>
              <a:ext uri="{FF2B5EF4-FFF2-40B4-BE49-F238E27FC236}">
                <a16:creationId xmlns:a16="http://schemas.microsoft.com/office/drawing/2014/main" id="{C5B8E98E-A268-758F-30C9-D8BA381D504C}"/>
              </a:ext>
            </a:extLst>
          </p:cNvPr>
          <p:cNvGrpSpPr/>
          <p:nvPr/>
        </p:nvGrpSpPr>
        <p:grpSpPr>
          <a:xfrm>
            <a:off x="170772" y="306825"/>
            <a:ext cx="9139171" cy="5892383"/>
            <a:chOff x="129208" y="338963"/>
            <a:chExt cx="9139171" cy="5892383"/>
          </a:xfrm>
        </p:grpSpPr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9320148F-DBAF-7A54-53A9-973158BCEB90}"/>
                </a:ext>
              </a:extLst>
            </p:cNvPr>
            <p:cNvGrpSpPr/>
            <p:nvPr/>
          </p:nvGrpSpPr>
          <p:grpSpPr>
            <a:xfrm>
              <a:off x="129208" y="338963"/>
              <a:ext cx="9139171" cy="5892383"/>
              <a:chOff x="655680" y="228126"/>
              <a:chExt cx="9139171" cy="5892383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0E153D6E-2439-49C9-D2D9-2DD3C233B61E}"/>
                  </a:ext>
                </a:extLst>
              </p:cNvPr>
              <p:cNvGrpSpPr/>
              <p:nvPr/>
            </p:nvGrpSpPr>
            <p:grpSpPr>
              <a:xfrm>
                <a:off x="655681" y="228126"/>
                <a:ext cx="7730398" cy="5789559"/>
                <a:chOff x="1027288" y="734857"/>
                <a:chExt cx="7730398" cy="5789559"/>
              </a:xfrm>
            </p:grpSpPr>
            <p:grpSp>
              <p:nvGrpSpPr>
                <p:cNvPr id="3" name="Group 2">
                  <a:extLst>
                    <a:ext uri="{FF2B5EF4-FFF2-40B4-BE49-F238E27FC236}">
                      <a16:creationId xmlns:a16="http://schemas.microsoft.com/office/drawing/2014/main" id="{D1A61C12-ACA0-8D19-28BF-22ABA93D671D}"/>
                    </a:ext>
                  </a:extLst>
                </p:cNvPr>
                <p:cNvGrpSpPr/>
                <p:nvPr/>
              </p:nvGrpSpPr>
              <p:grpSpPr>
                <a:xfrm>
                  <a:off x="3887460" y="739860"/>
                  <a:ext cx="2956682" cy="2961148"/>
                  <a:chOff x="4135825" y="1146697"/>
                  <a:chExt cx="3872102" cy="4344873"/>
                </a:xfrm>
              </p:grpSpPr>
              <p:sp>
                <p:nvSpPr>
                  <p:cNvPr id="41" name="Rectangle 40">
                    <a:extLst>
                      <a:ext uri="{FF2B5EF4-FFF2-40B4-BE49-F238E27FC236}">
                        <a16:creationId xmlns:a16="http://schemas.microsoft.com/office/drawing/2014/main" id="{CE4477BA-9B31-57A5-E7A8-A971C9621D6F}"/>
                      </a:ext>
                    </a:extLst>
                  </p:cNvPr>
                  <p:cNvSpPr/>
                  <p:nvPr/>
                </p:nvSpPr>
                <p:spPr>
                  <a:xfrm>
                    <a:off x="4232588" y="1191491"/>
                    <a:ext cx="3775339" cy="4300079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200">
                      <a:ln>
                        <a:solidFill>
                          <a:srgbClr val="FFC000"/>
                        </a:solidFill>
                      </a:ln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0E5A147E-4091-E841-36A7-E96B4629D625}"/>
                      </a:ext>
                    </a:extLst>
                  </p:cNvPr>
                  <p:cNvSpPr txBox="1"/>
                  <p:nvPr/>
                </p:nvSpPr>
                <p:spPr>
                  <a:xfrm>
                    <a:off x="4135825" y="1146697"/>
                    <a:ext cx="2532569" cy="4967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dirty="0">
                        <a:solidFill>
                          <a:schemeClr val="bg1"/>
                        </a:solidFill>
                        <a:highlight>
                          <a:srgbClr val="000000"/>
                        </a:highlight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: Experiment-2</a:t>
                    </a:r>
                  </a:p>
                </p:txBody>
              </p:sp>
            </p:grpSp>
            <p:grpSp>
              <p:nvGrpSpPr>
                <p:cNvPr id="4" name="Group 3">
                  <a:extLst>
                    <a:ext uri="{FF2B5EF4-FFF2-40B4-BE49-F238E27FC236}">
                      <a16:creationId xmlns:a16="http://schemas.microsoft.com/office/drawing/2014/main" id="{385C9369-C152-35AB-3320-511C0CEB15EA}"/>
                    </a:ext>
                  </a:extLst>
                </p:cNvPr>
                <p:cNvGrpSpPr/>
                <p:nvPr/>
              </p:nvGrpSpPr>
              <p:grpSpPr>
                <a:xfrm>
                  <a:off x="1077747" y="734857"/>
                  <a:ext cx="7679939" cy="5789559"/>
                  <a:chOff x="8115059" y="-3316514"/>
                  <a:chExt cx="10599925" cy="8808084"/>
                </a:xfrm>
              </p:grpSpPr>
              <p:sp>
                <p:nvSpPr>
                  <p:cNvPr id="25" name="Rectangle 24">
                    <a:extLst>
                      <a:ext uri="{FF2B5EF4-FFF2-40B4-BE49-F238E27FC236}">
                        <a16:creationId xmlns:a16="http://schemas.microsoft.com/office/drawing/2014/main" id="{D77E5D3E-574D-1770-2BD9-3D7DFEE02886}"/>
                      </a:ext>
                    </a:extLst>
                  </p:cNvPr>
                  <p:cNvSpPr/>
                  <p:nvPr/>
                </p:nvSpPr>
                <p:spPr>
                  <a:xfrm>
                    <a:off x="8115059" y="1196109"/>
                    <a:ext cx="3947631" cy="4295461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20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6" name="TextBox 25">
                    <a:extLst>
                      <a:ext uri="{FF2B5EF4-FFF2-40B4-BE49-F238E27FC236}">
                        <a16:creationId xmlns:a16="http://schemas.microsoft.com/office/drawing/2014/main" id="{0BAFB107-B13A-967A-4D0B-31B19F45DFEF}"/>
                      </a:ext>
                    </a:extLst>
                  </p:cNvPr>
                  <p:cNvSpPr txBox="1"/>
                  <p:nvPr/>
                </p:nvSpPr>
                <p:spPr>
                  <a:xfrm>
                    <a:off x="15959961" y="-3316514"/>
                    <a:ext cx="2755023" cy="51506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dirty="0">
                        <a:solidFill>
                          <a:schemeClr val="bg1"/>
                        </a:solidFill>
                        <a:highlight>
                          <a:srgbClr val="000000"/>
                        </a:highlight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: Experiment-3</a:t>
                    </a:r>
                  </a:p>
                </p:txBody>
              </p:sp>
            </p:grpSp>
            <p:sp>
              <p:nvSpPr>
                <p:cNvPr id="5" name="Rectangle 4">
                  <a:extLst>
                    <a:ext uri="{FF2B5EF4-FFF2-40B4-BE49-F238E27FC236}">
                      <a16:creationId xmlns:a16="http://schemas.microsoft.com/office/drawing/2014/main" id="{CC0856AD-92DE-B022-2FBA-6B89593B06B3}"/>
                    </a:ext>
                  </a:extLst>
                </p:cNvPr>
                <p:cNvSpPr/>
                <p:nvPr/>
              </p:nvSpPr>
              <p:spPr>
                <a:xfrm>
                  <a:off x="3948860" y="3692255"/>
                  <a:ext cx="2895284" cy="2832160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grpSp>
              <p:nvGrpSpPr>
                <p:cNvPr id="6" name="Group 5">
                  <a:extLst>
                    <a:ext uri="{FF2B5EF4-FFF2-40B4-BE49-F238E27FC236}">
                      <a16:creationId xmlns:a16="http://schemas.microsoft.com/office/drawing/2014/main" id="{F641232F-D8D7-125D-6ED6-715DB9552EC5}"/>
                    </a:ext>
                  </a:extLst>
                </p:cNvPr>
                <p:cNvGrpSpPr/>
                <p:nvPr/>
              </p:nvGrpSpPr>
              <p:grpSpPr>
                <a:xfrm>
                  <a:off x="1027288" y="734857"/>
                  <a:ext cx="2912910" cy="2960366"/>
                  <a:chOff x="33734" y="1147842"/>
                  <a:chExt cx="4083576" cy="4343728"/>
                </a:xfrm>
              </p:grpSpPr>
              <p:sp>
                <p:nvSpPr>
                  <p:cNvPr id="8" name="Rectangle 7">
                    <a:extLst>
                      <a:ext uri="{FF2B5EF4-FFF2-40B4-BE49-F238E27FC236}">
                        <a16:creationId xmlns:a16="http://schemas.microsoft.com/office/drawing/2014/main" id="{B8C681DF-8AFD-7114-AB6C-D002D0CD0461}"/>
                      </a:ext>
                    </a:extLst>
                  </p:cNvPr>
                  <p:cNvSpPr/>
                  <p:nvPr/>
                </p:nvSpPr>
                <p:spPr>
                  <a:xfrm>
                    <a:off x="129310" y="1191491"/>
                    <a:ext cx="3988000" cy="4300079"/>
                  </a:xfrm>
                  <a:prstGeom prst="rect">
                    <a:avLst/>
                  </a:prstGeom>
                  <a:no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" name="TextBox 8">
                    <a:extLst>
                      <a:ext uri="{FF2B5EF4-FFF2-40B4-BE49-F238E27FC236}">
                        <a16:creationId xmlns:a16="http://schemas.microsoft.com/office/drawing/2014/main" id="{AC019AAE-0694-5C7A-AFB6-2D645220891B}"/>
                      </a:ext>
                    </a:extLst>
                  </p:cNvPr>
                  <p:cNvSpPr txBox="1"/>
                  <p:nvPr/>
                </p:nvSpPr>
                <p:spPr>
                  <a:xfrm>
                    <a:off x="33734" y="1147842"/>
                    <a:ext cx="2500759" cy="4967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dirty="0">
                        <a:solidFill>
                          <a:schemeClr val="bg1"/>
                        </a:solidFill>
                        <a:highlight>
                          <a:srgbClr val="000000"/>
                        </a:highlight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: Experiment-1</a:t>
                    </a:r>
                  </a:p>
                </p:txBody>
              </p:sp>
            </p:grpSp>
          </p:grpSp>
          <p:sp>
            <p:nvSpPr>
              <p:cNvPr id="58" name="Rectangle 57">
                <a:extLst>
                  <a:ext uri="{FF2B5EF4-FFF2-40B4-BE49-F238E27FC236}">
                    <a16:creationId xmlns:a16="http://schemas.microsoft.com/office/drawing/2014/main" id="{6ADAA058-21FB-5EB1-EF36-5AB3F2057667}"/>
                  </a:ext>
                </a:extLst>
              </p:cNvPr>
              <p:cNvSpPr/>
              <p:nvPr/>
            </p:nvSpPr>
            <p:spPr>
              <a:xfrm>
                <a:off x="3594112" y="257874"/>
                <a:ext cx="2844733" cy="293061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B21EE91C-2C92-5CBE-B6E8-13735D6D4C75}"/>
                  </a:ext>
                </a:extLst>
              </p:cNvPr>
              <p:cNvSpPr/>
              <p:nvPr/>
            </p:nvSpPr>
            <p:spPr>
              <a:xfrm>
                <a:off x="6460212" y="257874"/>
                <a:ext cx="2844733" cy="293061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335A40D8-0EE4-00B6-8568-C7E79DAF1918}"/>
                  </a:ext>
                </a:extLst>
              </p:cNvPr>
              <p:cNvGrpSpPr/>
              <p:nvPr/>
            </p:nvGrpSpPr>
            <p:grpSpPr>
              <a:xfrm>
                <a:off x="655680" y="3154288"/>
                <a:ext cx="8460243" cy="2510498"/>
                <a:chOff x="553524" y="746913"/>
                <a:chExt cx="9963080" cy="2510498"/>
              </a:xfrm>
            </p:grpSpPr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D6134577-5DD8-3B29-6A8C-FE6177A27424}"/>
                    </a:ext>
                  </a:extLst>
                </p:cNvPr>
                <p:cNvSpPr txBox="1"/>
                <p:nvPr/>
              </p:nvSpPr>
              <p:spPr>
                <a:xfrm>
                  <a:off x="2277420" y="1964199"/>
                  <a:ext cx="84245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:2243 </a:t>
                  </a:r>
                  <a:r>
                    <a:rPr lang="en-US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18)</a:t>
                  </a:r>
                  <a:endParaRPr kumimoji="0" lang="en-US" sz="11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Oval 67">
                  <a:extLst>
                    <a:ext uri="{FF2B5EF4-FFF2-40B4-BE49-F238E27FC236}">
                      <a16:creationId xmlns:a16="http://schemas.microsoft.com/office/drawing/2014/main" id="{49A7E0F3-B0E0-E423-B440-0339669C4DD5}"/>
                    </a:ext>
                  </a:extLst>
                </p:cNvPr>
                <p:cNvSpPr/>
                <p:nvPr/>
              </p:nvSpPr>
              <p:spPr>
                <a:xfrm>
                  <a:off x="8028067" y="1306798"/>
                  <a:ext cx="1629046" cy="1463040"/>
                </a:xfrm>
                <a:prstGeom prst="ellipse">
                  <a:avLst/>
                </a:prstGeom>
                <a:solidFill>
                  <a:srgbClr val="00B0F0">
                    <a:alpha val="30196"/>
                  </a:srgb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05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91F778CD-CFD4-4CFF-5025-AB07616E3D0D}"/>
                    </a:ext>
                  </a:extLst>
                </p:cNvPr>
                <p:cNvSpPr txBox="1"/>
                <p:nvPr/>
              </p:nvSpPr>
              <p:spPr>
                <a:xfrm>
                  <a:off x="837048" y="1889336"/>
                  <a:ext cx="92189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:1463 </a:t>
                  </a:r>
                  <a:r>
                    <a:rPr lang="en-US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29)</a:t>
                  </a:r>
                  <a:endParaRPr kumimoji="0" lang="en-US" sz="11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0C277135-EEE2-B3CF-699D-4A0ED6140608}"/>
                    </a:ext>
                  </a:extLst>
                </p:cNvPr>
                <p:cNvSpPr txBox="1"/>
                <p:nvPr/>
              </p:nvSpPr>
              <p:spPr>
                <a:xfrm>
                  <a:off x="1695356" y="1899208"/>
                  <a:ext cx="73254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:510 </a:t>
                  </a:r>
                  <a:r>
                    <a:rPr lang="en-US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1)</a:t>
                  </a:r>
                  <a:endParaRPr kumimoji="0" lang="en-US" sz="11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7F3C59CF-0EAC-51E0-3CBD-312A3B9D45E8}"/>
                    </a:ext>
                  </a:extLst>
                </p:cNvPr>
                <p:cNvSpPr txBox="1"/>
                <p:nvPr/>
              </p:nvSpPr>
              <p:spPr>
                <a:xfrm>
                  <a:off x="553524" y="746913"/>
                  <a:ext cx="226940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>
                      <a:solidFill>
                        <a:schemeClr val="bg1"/>
                      </a:solidFill>
                      <a:highlight>
                        <a:srgbClr val="000000"/>
                      </a:highlight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: Experiment-1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C5ECF417-16D9-CA59-1A02-F7F59C11F46E}"/>
                    </a:ext>
                  </a:extLst>
                </p:cNvPr>
                <p:cNvSpPr txBox="1"/>
                <p:nvPr/>
              </p:nvSpPr>
              <p:spPr>
                <a:xfrm>
                  <a:off x="9660266" y="1903940"/>
                  <a:ext cx="79607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:339 </a:t>
                  </a:r>
                  <a:r>
                    <a:rPr lang="en-US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0)</a:t>
                  </a:r>
                  <a:endParaRPr kumimoji="0" lang="en-US" sz="11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Oval 73">
                  <a:extLst>
                    <a:ext uri="{FF2B5EF4-FFF2-40B4-BE49-F238E27FC236}">
                      <a16:creationId xmlns:a16="http://schemas.microsoft.com/office/drawing/2014/main" id="{5B7D81C2-06C1-F72F-4E9F-929BE1D45083}"/>
                    </a:ext>
                  </a:extLst>
                </p:cNvPr>
                <p:cNvSpPr/>
                <p:nvPr/>
              </p:nvSpPr>
              <p:spPr>
                <a:xfrm>
                  <a:off x="1709242" y="1378984"/>
                  <a:ext cx="1463040" cy="1463041"/>
                </a:xfrm>
                <a:prstGeom prst="ellipse">
                  <a:avLst/>
                </a:prstGeom>
                <a:solidFill>
                  <a:srgbClr val="FFC000">
                    <a:alpha val="20000"/>
                  </a:srgb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002AC4BD-56DC-2615-C0B9-A0134EE512E6}"/>
                    </a:ext>
                  </a:extLst>
                </p:cNvPr>
                <p:cNvSpPr txBox="1"/>
                <p:nvPr/>
              </p:nvSpPr>
              <p:spPr>
                <a:xfrm>
                  <a:off x="8264563" y="1876530"/>
                  <a:ext cx="796078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:607 </a:t>
                  </a:r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26)</a:t>
                  </a:r>
                  <a:endPara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3FA5D3AF-9EC2-D3E7-86A2-63875266ADA8}"/>
                    </a:ext>
                  </a:extLst>
                </p:cNvPr>
                <p:cNvSpPr txBox="1"/>
                <p:nvPr/>
              </p:nvSpPr>
              <p:spPr>
                <a:xfrm>
                  <a:off x="9067718" y="1894666"/>
                  <a:ext cx="65784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:23 </a:t>
                  </a:r>
                  <a:r>
                    <a:rPr lang="en-US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0)</a:t>
                  </a:r>
                  <a:endParaRPr kumimoji="0" lang="en-US" sz="11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Oval 76">
                  <a:extLst>
                    <a:ext uri="{FF2B5EF4-FFF2-40B4-BE49-F238E27FC236}">
                      <a16:creationId xmlns:a16="http://schemas.microsoft.com/office/drawing/2014/main" id="{FFB900B4-2232-6F20-848D-EC3F48986534}"/>
                    </a:ext>
                  </a:extLst>
                </p:cNvPr>
                <p:cNvSpPr/>
                <p:nvPr/>
              </p:nvSpPr>
              <p:spPr>
                <a:xfrm>
                  <a:off x="872075" y="1363483"/>
                  <a:ext cx="1463041" cy="1463041"/>
                </a:xfrm>
                <a:prstGeom prst="ellipse">
                  <a:avLst/>
                </a:prstGeom>
                <a:solidFill>
                  <a:srgbClr val="00B0F0">
                    <a:alpha val="29804"/>
                  </a:srgb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highlight>
                      <a:srgbClr val="00FF00"/>
                    </a:highlight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Oval 77">
                  <a:extLst>
                    <a:ext uri="{FF2B5EF4-FFF2-40B4-BE49-F238E27FC236}">
                      <a16:creationId xmlns:a16="http://schemas.microsoft.com/office/drawing/2014/main" id="{706134FA-8526-11AA-57F8-5847CCDAE310}"/>
                    </a:ext>
                  </a:extLst>
                </p:cNvPr>
                <p:cNvSpPr/>
                <p:nvPr/>
              </p:nvSpPr>
              <p:spPr>
                <a:xfrm>
                  <a:off x="9053564" y="1314520"/>
                  <a:ext cx="1463040" cy="1463040"/>
                </a:xfrm>
                <a:prstGeom prst="ellipse">
                  <a:avLst/>
                </a:prstGeom>
                <a:solidFill>
                  <a:srgbClr val="FFC000">
                    <a:alpha val="20000"/>
                  </a:srgb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Trade Gothic Next Light"/>
                    <a:ea typeface="+mn-ea"/>
                    <a:cs typeface="+mn-cs"/>
                  </a:endParaRPr>
                </a:p>
              </p:txBody>
            </p:sp>
            <p:sp>
              <p:nvSpPr>
                <p:cNvPr id="79" name="Rectangle 78">
                  <a:extLst>
                    <a:ext uri="{FF2B5EF4-FFF2-40B4-BE49-F238E27FC236}">
                      <a16:creationId xmlns:a16="http://schemas.microsoft.com/office/drawing/2014/main" id="{961FECE1-160F-9A98-BCB6-5C3ECF8A8702}"/>
                    </a:ext>
                  </a:extLst>
                </p:cNvPr>
                <p:cNvSpPr/>
                <p:nvPr/>
              </p:nvSpPr>
              <p:spPr>
                <a:xfrm>
                  <a:off x="2210818" y="2826524"/>
                  <a:ext cx="1774052" cy="43088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edium Dose vs. Placebo</a:t>
                  </a:r>
                  <a:endParaRPr kumimoji="0" lang="en-US" sz="11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Rectangle 80">
                  <a:extLst>
                    <a:ext uri="{FF2B5EF4-FFF2-40B4-BE49-F238E27FC236}">
                      <a16:creationId xmlns:a16="http://schemas.microsoft.com/office/drawing/2014/main" id="{384FBD2A-18C1-F92C-4D19-3B9480CD495C}"/>
                    </a:ext>
                  </a:extLst>
                </p:cNvPr>
                <p:cNvSpPr/>
                <p:nvPr/>
              </p:nvSpPr>
              <p:spPr>
                <a:xfrm>
                  <a:off x="553526" y="1079693"/>
                  <a:ext cx="1744079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100" b="1" i="0" u="none" strike="noStrike" kern="120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igh Dose vs. Placebo</a:t>
                  </a:r>
                  <a:endParaRPr kumimoji="0" lang="en-US" sz="11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82" name="Group 81">
                  <a:extLst>
                    <a:ext uri="{FF2B5EF4-FFF2-40B4-BE49-F238E27FC236}">
                      <a16:creationId xmlns:a16="http://schemas.microsoft.com/office/drawing/2014/main" id="{2B53A1A8-1579-0C1A-4D05-9963103DEBAD}"/>
                    </a:ext>
                  </a:extLst>
                </p:cNvPr>
                <p:cNvGrpSpPr/>
                <p:nvPr/>
              </p:nvGrpSpPr>
              <p:grpSpPr>
                <a:xfrm>
                  <a:off x="4141354" y="1095510"/>
                  <a:ext cx="3650264" cy="2144057"/>
                  <a:chOff x="4141354" y="1095510"/>
                  <a:chExt cx="3650264" cy="2144057"/>
                </a:xfrm>
              </p:grpSpPr>
              <p:sp>
                <p:nvSpPr>
                  <p:cNvPr id="85" name="Oval 84">
                    <a:extLst>
                      <a:ext uri="{FF2B5EF4-FFF2-40B4-BE49-F238E27FC236}">
                        <a16:creationId xmlns:a16="http://schemas.microsoft.com/office/drawing/2014/main" id="{12BFD024-9C4D-1643-FF96-82DE77BB08F1}"/>
                      </a:ext>
                    </a:extLst>
                  </p:cNvPr>
                  <p:cNvSpPr/>
                  <p:nvPr/>
                </p:nvSpPr>
                <p:spPr>
                  <a:xfrm>
                    <a:off x="5427852" y="1370670"/>
                    <a:ext cx="1629048" cy="1463042"/>
                  </a:xfrm>
                  <a:prstGeom prst="ellipse">
                    <a:avLst/>
                  </a:prstGeom>
                  <a:solidFill>
                    <a:srgbClr val="FFC000">
                      <a:alpha val="20000"/>
                    </a:srgbClr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05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6" name="Rectangle 85">
                    <a:extLst>
                      <a:ext uri="{FF2B5EF4-FFF2-40B4-BE49-F238E27FC236}">
                        <a16:creationId xmlns:a16="http://schemas.microsoft.com/office/drawing/2014/main" id="{0A038116-AB0D-0AAC-02FF-15A1363A7F0A}"/>
                      </a:ext>
                    </a:extLst>
                  </p:cNvPr>
                  <p:cNvSpPr/>
                  <p:nvPr/>
                </p:nvSpPr>
                <p:spPr>
                  <a:xfrm>
                    <a:off x="5917008" y="2808680"/>
                    <a:ext cx="1874610" cy="43088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edium Dose vs. Placebo</a:t>
                    </a:r>
                    <a:endParaRPr kumimoji="0" lang="en-US" sz="1100" b="0" i="0" u="none" strike="noStrike" kern="120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7" name="Rectangle 86">
                    <a:extLst>
                      <a:ext uri="{FF2B5EF4-FFF2-40B4-BE49-F238E27FC236}">
                        <a16:creationId xmlns:a16="http://schemas.microsoft.com/office/drawing/2014/main" id="{4C450C76-D95B-1B9A-F562-F07B62C7D645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>
                    <a:off x="4141354" y="1095510"/>
                    <a:ext cx="1706900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igh Dose vs</a:t>
                    </a:r>
                    <a:r>
                      <a:rPr 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.</a:t>
                    </a:r>
                    <a:r>
                      <a: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lacebo</a:t>
                    </a:r>
                    <a:endParaRPr kumimoji="0" lang="en-US" sz="1100" b="0" i="0" u="none" strike="noStrike" kern="120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8" name="Oval 87">
                    <a:extLst>
                      <a:ext uri="{FF2B5EF4-FFF2-40B4-BE49-F238E27FC236}">
                        <a16:creationId xmlns:a16="http://schemas.microsoft.com/office/drawing/2014/main" id="{E51151FE-FAE7-D86D-6A58-196E99D4B2DE}"/>
                      </a:ext>
                    </a:extLst>
                  </p:cNvPr>
                  <p:cNvSpPr/>
                  <p:nvPr/>
                </p:nvSpPr>
                <p:spPr>
                  <a:xfrm>
                    <a:off x="4441559" y="1345640"/>
                    <a:ext cx="1629047" cy="1463040"/>
                  </a:xfrm>
                  <a:prstGeom prst="ellipse">
                    <a:avLst/>
                  </a:prstGeom>
                  <a:solidFill>
                    <a:srgbClr val="00B0F0">
                      <a:alpha val="30196"/>
                    </a:srgbClr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05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9" name="TextBox 88">
                    <a:extLst>
                      <a:ext uri="{FF2B5EF4-FFF2-40B4-BE49-F238E27FC236}">
                        <a16:creationId xmlns:a16="http://schemas.microsoft.com/office/drawing/2014/main" id="{20A6D910-503F-D1FF-19B4-54F6C350C272}"/>
                      </a:ext>
                    </a:extLst>
                  </p:cNvPr>
                  <p:cNvSpPr txBox="1"/>
                  <p:nvPr/>
                </p:nvSpPr>
                <p:spPr>
                  <a:xfrm>
                    <a:off x="6199115" y="1964199"/>
                    <a:ext cx="777037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b:761 </a:t>
                    </a:r>
                    <a:r>
                      <a: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3)</a:t>
                    </a:r>
                    <a:endPara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0" name="TextBox 89">
                    <a:extLst>
                      <a:ext uri="{FF2B5EF4-FFF2-40B4-BE49-F238E27FC236}">
                        <a16:creationId xmlns:a16="http://schemas.microsoft.com/office/drawing/2014/main" id="{AD776B90-DDD8-313D-0F4A-1D76A7429B76}"/>
                      </a:ext>
                    </a:extLst>
                  </p:cNvPr>
                  <p:cNvSpPr txBox="1"/>
                  <p:nvPr/>
                </p:nvSpPr>
                <p:spPr>
                  <a:xfrm>
                    <a:off x="4546188" y="1863139"/>
                    <a:ext cx="777037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:774 </a:t>
                    </a:r>
                    <a:r>
                      <a: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2)</a:t>
                    </a:r>
                    <a:endPara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1" name="TextBox 90">
                    <a:extLst>
                      <a:ext uri="{FF2B5EF4-FFF2-40B4-BE49-F238E27FC236}">
                        <a16:creationId xmlns:a16="http://schemas.microsoft.com/office/drawing/2014/main" id="{69656879-F14E-0FD0-936D-00D601F5A1CF}"/>
                      </a:ext>
                    </a:extLst>
                  </p:cNvPr>
                  <p:cNvSpPr txBox="1"/>
                  <p:nvPr/>
                </p:nvSpPr>
                <p:spPr>
                  <a:xfrm>
                    <a:off x="5414986" y="1899208"/>
                    <a:ext cx="715675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:387 </a:t>
                    </a:r>
                    <a:r>
                      <a: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0)</a:t>
                    </a:r>
                  </a:p>
                </p:txBody>
              </p:sp>
            </p:grp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41B0C98F-0C41-46F3-2670-01B8F0E20A8B}"/>
                    </a:ext>
                  </a:extLst>
                </p:cNvPr>
                <p:cNvSpPr txBox="1"/>
                <p:nvPr/>
              </p:nvSpPr>
              <p:spPr>
                <a:xfrm>
                  <a:off x="3921763" y="748362"/>
                  <a:ext cx="248262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>
                      <a:solidFill>
                        <a:schemeClr val="bg1"/>
                      </a:solidFill>
                      <a:highlight>
                        <a:srgbClr val="000000"/>
                      </a:highlight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: Experiment -2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83203787-DDBB-9D42-DE94-59B320097ABF}"/>
                    </a:ext>
                  </a:extLst>
                </p:cNvPr>
                <p:cNvSpPr txBox="1"/>
                <p:nvPr/>
              </p:nvSpPr>
              <p:spPr>
                <a:xfrm>
                  <a:off x="7322649" y="761826"/>
                  <a:ext cx="222851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>
                      <a:solidFill>
                        <a:schemeClr val="bg1"/>
                      </a:solidFill>
                      <a:highlight>
                        <a:srgbClr val="000000"/>
                      </a:highlight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: Experiment-3</a:t>
                  </a:r>
                </a:p>
              </p:txBody>
            </p:sp>
          </p:grpSp>
          <p:sp>
            <p:nvSpPr>
              <p:cNvPr id="92" name="Rectangle 91">
                <a:extLst>
                  <a:ext uri="{FF2B5EF4-FFF2-40B4-BE49-F238E27FC236}">
                    <a16:creationId xmlns:a16="http://schemas.microsoft.com/office/drawing/2014/main" id="{57ECAFD7-3B02-F0A9-E0BD-DAB6A27F9984}"/>
                  </a:ext>
                </a:extLst>
              </p:cNvPr>
              <p:cNvSpPr/>
              <p:nvPr/>
            </p:nvSpPr>
            <p:spPr>
              <a:xfrm>
                <a:off x="725906" y="3189890"/>
                <a:ext cx="2844733" cy="293061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Rectangle 92">
                <a:extLst>
                  <a:ext uri="{FF2B5EF4-FFF2-40B4-BE49-F238E27FC236}">
                    <a16:creationId xmlns:a16="http://schemas.microsoft.com/office/drawing/2014/main" id="{E4D7AD14-BEDF-D246-0DB0-AB64E45CDAF5}"/>
                  </a:ext>
                </a:extLst>
              </p:cNvPr>
              <p:cNvSpPr/>
              <p:nvPr/>
            </p:nvSpPr>
            <p:spPr>
              <a:xfrm>
                <a:off x="3594112" y="3189889"/>
                <a:ext cx="2844733" cy="293061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5BFA2877-2D72-D0F7-CB12-F8CA7E1C4CEC}"/>
                  </a:ext>
                </a:extLst>
              </p:cNvPr>
              <p:cNvSpPr/>
              <p:nvPr/>
            </p:nvSpPr>
            <p:spPr>
              <a:xfrm>
                <a:off x="6449940" y="3189888"/>
                <a:ext cx="2855005" cy="293061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id="{4B7DFB64-50B3-E005-FA94-E4184C61706A}"/>
                  </a:ext>
                </a:extLst>
              </p:cNvPr>
              <p:cNvSpPr/>
              <p:nvPr/>
            </p:nvSpPr>
            <p:spPr>
              <a:xfrm>
                <a:off x="8203008" y="5144010"/>
                <a:ext cx="1591843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dium Dose vs. Placebo</a:t>
                </a:r>
                <a:endParaRPr kumimoji="0" lang="en-US" sz="11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id="{E36962D4-3BC7-4231-0824-37EB93E02FF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512852" y="3487068"/>
                <a:ext cx="144943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gh Dose vs</a:t>
                </a:r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</a:t>
                </a:r>
                <a:r>
                  <a:rPr kumimoji="0" lang="en-US" sz="11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cebo</a:t>
                </a:r>
                <a:endParaRPr kumimoji="0" lang="en-US" sz="11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6909E77C-9339-BD89-9D0E-7FAF585DAD10}"/>
                </a:ext>
              </a:extLst>
            </p:cNvPr>
            <p:cNvGrpSpPr/>
            <p:nvPr/>
          </p:nvGrpSpPr>
          <p:grpSpPr>
            <a:xfrm>
              <a:off x="436977" y="863511"/>
              <a:ext cx="2410174" cy="2278671"/>
              <a:chOff x="1371600" y="1047270"/>
              <a:chExt cx="2410174" cy="2278671"/>
            </a:xfrm>
          </p:grpSpPr>
          <p:sp>
            <p:nvSpPr>
              <p:cNvPr id="69" name="Oval 68">
                <a:extLst>
                  <a:ext uri="{FF2B5EF4-FFF2-40B4-BE49-F238E27FC236}">
                    <a16:creationId xmlns:a16="http://schemas.microsoft.com/office/drawing/2014/main" id="{7D3EC91B-07ED-0C9A-397A-5FBCEAC79EE1}"/>
                  </a:ext>
                </a:extLst>
              </p:cNvPr>
              <p:cNvSpPr/>
              <p:nvPr/>
            </p:nvSpPr>
            <p:spPr>
              <a:xfrm>
                <a:off x="1371600" y="1104159"/>
                <a:ext cx="1463039" cy="1463041"/>
              </a:xfrm>
              <a:prstGeom prst="ellipse">
                <a:avLst/>
              </a:prstGeom>
              <a:solidFill>
                <a:srgbClr val="FFA7A9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Oval 79">
                <a:extLst>
                  <a:ext uri="{FF2B5EF4-FFF2-40B4-BE49-F238E27FC236}">
                    <a16:creationId xmlns:a16="http://schemas.microsoft.com/office/drawing/2014/main" id="{D44A5CDC-1CD0-BD97-6227-34D2152DE725}"/>
                  </a:ext>
                </a:extLst>
              </p:cNvPr>
              <p:cNvSpPr/>
              <p:nvPr/>
            </p:nvSpPr>
            <p:spPr>
              <a:xfrm>
                <a:off x="2286000" y="1047270"/>
                <a:ext cx="1463041" cy="1463041"/>
              </a:xfrm>
              <a:prstGeom prst="ellipse">
                <a:avLst/>
              </a:prstGeom>
              <a:solidFill>
                <a:schemeClr val="bg2">
                  <a:lumMod val="90000"/>
                  <a:alpha val="2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6CB0ABA1-B8AD-B93B-3411-5E9F32CE9EBC}"/>
                  </a:ext>
                </a:extLst>
              </p:cNvPr>
              <p:cNvSpPr txBox="1"/>
              <p:nvPr/>
            </p:nvSpPr>
            <p:spPr>
              <a:xfrm>
                <a:off x="1507876" y="1494249"/>
                <a:ext cx="881171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:1108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160)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Oval 99">
                <a:extLst>
                  <a:ext uri="{FF2B5EF4-FFF2-40B4-BE49-F238E27FC236}">
                    <a16:creationId xmlns:a16="http://schemas.microsoft.com/office/drawing/2014/main" id="{6FEC12C2-8D62-D81A-5CE2-5613DB5075D5}"/>
                  </a:ext>
                </a:extLst>
              </p:cNvPr>
              <p:cNvSpPr/>
              <p:nvPr/>
            </p:nvSpPr>
            <p:spPr>
              <a:xfrm>
                <a:off x="1920240" y="1862901"/>
                <a:ext cx="1463040" cy="1463040"/>
              </a:xfrm>
              <a:prstGeom prst="ellipse">
                <a:avLst/>
              </a:prstGeom>
              <a:solidFill>
                <a:srgbClr val="00B050">
                  <a:alpha val="29804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65DBE9AF-8153-B63F-AFF2-22A613869F49}"/>
                  </a:ext>
                </a:extLst>
              </p:cNvPr>
              <p:cNvSpPr txBox="1"/>
              <p:nvPr/>
            </p:nvSpPr>
            <p:spPr>
              <a:xfrm>
                <a:off x="2331949" y="1439387"/>
                <a:ext cx="58905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:272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FC1D2A7F-01BB-7DE5-67B6-2A8FB2D736DA}"/>
                  </a:ext>
                </a:extLst>
              </p:cNvPr>
              <p:cNvSpPr txBox="1"/>
              <p:nvPr/>
            </p:nvSpPr>
            <p:spPr>
              <a:xfrm>
                <a:off x="2929363" y="1559731"/>
                <a:ext cx="85241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:2043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18)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7C5754A7-61FA-16DB-4E9A-C892E5FD3FA7}"/>
                  </a:ext>
                </a:extLst>
              </p:cNvPr>
              <p:cNvSpPr txBox="1"/>
              <p:nvPr/>
            </p:nvSpPr>
            <p:spPr>
              <a:xfrm>
                <a:off x="1986975" y="2142096"/>
                <a:ext cx="59889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:104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2)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9DCF457F-262A-8D10-223A-61EFAE017126}"/>
                  </a:ext>
                </a:extLst>
              </p:cNvPr>
              <p:cNvSpPr txBox="1"/>
              <p:nvPr/>
            </p:nvSpPr>
            <p:spPr>
              <a:xfrm>
                <a:off x="2217874" y="2711682"/>
                <a:ext cx="89861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:1563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9)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C54818DA-314E-6780-A6C3-90EDAAB8161A}"/>
                  </a:ext>
                </a:extLst>
              </p:cNvPr>
              <p:cNvSpPr txBox="1"/>
              <p:nvPr/>
            </p:nvSpPr>
            <p:spPr>
              <a:xfrm>
                <a:off x="2393512" y="1850648"/>
                <a:ext cx="58905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:19 </a:t>
                </a: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542886CB-2C36-BBAC-1EC2-2D72426CDA83}"/>
                  </a:ext>
                </a:extLst>
              </p:cNvPr>
              <p:cNvSpPr txBox="1"/>
              <p:nvPr/>
            </p:nvSpPr>
            <p:spPr>
              <a:xfrm>
                <a:off x="2774583" y="2053648"/>
                <a:ext cx="68969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:180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B3457A8C-F024-9791-FA82-B048DDE6E167}"/>
                </a:ext>
              </a:extLst>
            </p:cNvPr>
            <p:cNvSpPr/>
            <p:nvPr/>
          </p:nvSpPr>
          <p:spPr>
            <a:xfrm>
              <a:off x="279522" y="707265"/>
              <a:ext cx="91563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Binge Dose</a:t>
              </a:r>
              <a:endPara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45C6FBA5-8307-6F8A-7CB2-E9E82C053383}"/>
                </a:ext>
              </a:extLst>
            </p:cNvPr>
            <p:cNvSpPr/>
            <p:nvPr/>
          </p:nvSpPr>
          <p:spPr>
            <a:xfrm>
              <a:off x="715300" y="2950346"/>
              <a:ext cx="69923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lacebo</a:t>
              </a:r>
              <a:endPara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3642EDD1-0115-9B5A-1F53-2109667BEEA9}"/>
                </a:ext>
              </a:extLst>
            </p:cNvPr>
            <p:cNvSpPr/>
            <p:nvPr/>
          </p:nvSpPr>
          <p:spPr>
            <a:xfrm>
              <a:off x="1939356" y="624326"/>
              <a:ext cx="109517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edium Dose</a:t>
              </a:r>
              <a:endPara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5380FFF1-A92A-704A-AD00-2D1B4B8AD67A}"/>
                </a:ext>
              </a:extLst>
            </p:cNvPr>
            <p:cNvGrpSpPr/>
            <p:nvPr/>
          </p:nvGrpSpPr>
          <p:grpSpPr>
            <a:xfrm>
              <a:off x="3180930" y="678353"/>
              <a:ext cx="2689416" cy="2541447"/>
              <a:chOff x="4026940" y="872790"/>
              <a:chExt cx="2689416" cy="2541447"/>
            </a:xfrm>
          </p:grpSpPr>
          <p:sp>
            <p:nvSpPr>
              <p:cNvPr id="111" name="Oval 110">
                <a:extLst>
                  <a:ext uri="{FF2B5EF4-FFF2-40B4-BE49-F238E27FC236}">
                    <a16:creationId xmlns:a16="http://schemas.microsoft.com/office/drawing/2014/main" id="{A5F79E3A-C8E8-9F77-3C5E-6A493E500A44}"/>
                  </a:ext>
                </a:extLst>
              </p:cNvPr>
              <p:cNvSpPr/>
              <p:nvPr/>
            </p:nvSpPr>
            <p:spPr>
              <a:xfrm>
                <a:off x="4160066" y="1106424"/>
                <a:ext cx="1463040" cy="1458806"/>
              </a:xfrm>
              <a:prstGeom prst="ellipse">
                <a:avLst/>
              </a:prstGeom>
              <a:solidFill>
                <a:srgbClr val="FFA7A9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400" b="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Oval 111">
                <a:extLst>
                  <a:ext uri="{FF2B5EF4-FFF2-40B4-BE49-F238E27FC236}">
                    <a16:creationId xmlns:a16="http://schemas.microsoft.com/office/drawing/2014/main" id="{F0575E6C-4865-6E33-8462-33A4BCE0DAAD}"/>
                  </a:ext>
                </a:extLst>
              </p:cNvPr>
              <p:cNvSpPr/>
              <p:nvPr/>
            </p:nvSpPr>
            <p:spPr>
              <a:xfrm>
                <a:off x="5043176" y="1133856"/>
                <a:ext cx="1463040" cy="1463040"/>
              </a:xfrm>
              <a:prstGeom prst="ellipse">
                <a:avLst/>
              </a:prstGeom>
              <a:solidFill>
                <a:schemeClr val="bg2">
                  <a:lumMod val="90000"/>
                  <a:alpha val="2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9CD113C1-9FE1-0D67-1BDA-25057C574976}"/>
                  </a:ext>
                </a:extLst>
              </p:cNvPr>
              <p:cNvSpPr txBox="1"/>
              <p:nvPr/>
            </p:nvSpPr>
            <p:spPr>
              <a:xfrm>
                <a:off x="4430985" y="1480331"/>
                <a:ext cx="699781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:785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41F2A1C7-9531-2D17-6BE9-564E47B2A808}"/>
                  </a:ext>
                </a:extLst>
              </p:cNvPr>
              <p:cNvSpPr/>
              <p:nvPr/>
            </p:nvSpPr>
            <p:spPr>
              <a:xfrm>
                <a:off x="4026940" y="885551"/>
                <a:ext cx="91563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nge Dose</a:t>
                </a:r>
                <a:endParaRPr kumimoji="0" 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Oval 114">
                <a:extLst>
                  <a:ext uri="{FF2B5EF4-FFF2-40B4-BE49-F238E27FC236}">
                    <a16:creationId xmlns:a16="http://schemas.microsoft.com/office/drawing/2014/main" id="{9DC0DF63-D546-FED6-F31F-E91F5F30F39D}"/>
                  </a:ext>
                </a:extLst>
              </p:cNvPr>
              <p:cNvSpPr/>
              <p:nvPr/>
            </p:nvSpPr>
            <p:spPr>
              <a:xfrm>
                <a:off x="4663440" y="1865376"/>
                <a:ext cx="1463040" cy="1463040"/>
              </a:xfrm>
              <a:prstGeom prst="ellipse">
                <a:avLst/>
              </a:prstGeom>
              <a:solidFill>
                <a:srgbClr val="00B050">
                  <a:alpha val="30196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Rectangle 115">
                <a:extLst>
                  <a:ext uri="{FF2B5EF4-FFF2-40B4-BE49-F238E27FC236}">
                    <a16:creationId xmlns:a16="http://schemas.microsoft.com/office/drawing/2014/main" id="{B1DBF29A-3DB7-E21B-03B5-3A30B9A2DB6D}"/>
                  </a:ext>
                </a:extLst>
              </p:cNvPr>
              <p:cNvSpPr/>
              <p:nvPr/>
            </p:nvSpPr>
            <p:spPr>
              <a:xfrm>
                <a:off x="5749846" y="3137238"/>
                <a:ext cx="69923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cebo</a:t>
                </a:r>
                <a:endParaRPr kumimoji="0" 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Rectangle 116">
                <a:extLst>
                  <a:ext uri="{FF2B5EF4-FFF2-40B4-BE49-F238E27FC236}">
                    <a16:creationId xmlns:a16="http://schemas.microsoft.com/office/drawing/2014/main" id="{31C361CC-5168-325F-FFFB-132A241B4768}"/>
                  </a:ext>
                </a:extLst>
              </p:cNvPr>
              <p:cNvSpPr/>
              <p:nvPr/>
            </p:nvSpPr>
            <p:spPr>
              <a:xfrm>
                <a:off x="5621184" y="872790"/>
                <a:ext cx="109517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dium Dose</a:t>
                </a:r>
                <a:endParaRPr kumimoji="0" 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BEAF4968-481E-7F23-BA9F-F27C0766660A}"/>
                  </a:ext>
                </a:extLst>
              </p:cNvPr>
              <p:cNvSpPr txBox="1"/>
              <p:nvPr/>
            </p:nvSpPr>
            <p:spPr>
              <a:xfrm>
                <a:off x="5080669" y="1395888"/>
                <a:ext cx="63128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:154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49871E95-BD10-033D-B69D-02A27EF21EC0}"/>
                  </a:ext>
                </a:extLst>
              </p:cNvPr>
              <p:cNvSpPr txBox="1"/>
              <p:nvPr/>
            </p:nvSpPr>
            <p:spPr>
              <a:xfrm>
                <a:off x="5670621" y="1407412"/>
                <a:ext cx="904627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:1209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28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0A158B49-E79F-F76C-E878-4797917005D9}"/>
                  </a:ext>
                </a:extLst>
              </p:cNvPr>
              <p:cNvSpPr txBox="1"/>
              <p:nvPr/>
            </p:nvSpPr>
            <p:spPr>
              <a:xfrm>
                <a:off x="4736943" y="2086192"/>
                <a:ext cx="740621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:52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9E3FE585-9D0C-1FBF-992B-08C2CBA910BC}"/>
                  </a:ext>
                </a:extLst>
              </p:cNvPr>
              <p:cNvSpPr txBox="1"/>
              <p:nvPr/>
            </p:nvSpPr>
            <p:spPr>
              <a:xfrm>
                <a:off x="5131842" y="2600468"/>
                <a:ext cx="72964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:976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1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8E829B42-712A-B58C-AF9F-233C534208E1}"/>
                  </a:ext>
                </a:extLst>
              </p:cNvPr>
              <p:cNvSpPr txBox="1"/>
              <p:nvPr/>
            </p:nvSpPr>
            <p:spPr>
              <a:xfrm>
                <a:off x="5176286" y="1869007"/>
                <a:ext cx="631897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: 4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C738E0C2-F161-D995-54AB-0595E62148CF}"/>
                  </a:ext>
                </a:extLst>
              </p:cNvPr>
              <p:cNvSpPr txBox="1"/>
              <p:nvPr/>
            </p:nvSpPr>
            <p:spPr>
              <a:xfrm>
                <a:off x="5583378" y="2069442"/>
                <a:ext cx="679951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:68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7" name="Group 136">
              <a:extLst>
                <a:ext uri="{FF2B5EF4-FFF2-40B4-BE49-F238E27FC236}">
                  <a16:creationId xmlns:a16="http://schemas.microsoft.com/office/drawing/2014/main" id="{FE1DC158-C2D1-068E-7ABD-5ACCBBBC2BA6}"/>
                </a:ext>
              </a:extLst>
            </p:cNvPr>
            <p:cNvGrpSpPr/>
            <p:nvPr/>
          </p:nvGrpSpPr>
          <p:grpSpPr>
            <a:xfrm>
              <a:off x="6024098" y="672078"/>
              <a:ext cx="2584447" cy="2574024"/>
              <a:chOff x="1164594" y="3607566"/>
              <a:chExt cx="2584447" cy="2574024"/>
            </a:xfrm>
          </p:grpSpPr>
          <p:sp>
            <p:nvSpPr>
              <p:cNvPr id="125" name="Oval 124">
                <a:extLst>
                  <a:ext uri="{FF2B5EF4-FFF2-40B4-BE49-F238E27FC236}">
                    <a16:creationId xmlns:a16="http://schemas.microsoft.com/office/drawing/2014/main" id="{D1A42050-8AE0-CD79-C420-B5E351AF4699}"/>
                  </a:ext>
                </a:extLst>
              </p:cNvPr>
              <p:cNvSpPr/>
              <p:nvPr/>
            </p:nvSpPr>
            <p:spPr>
              <a:xfrm>
                <a:off x="1371600" y="3849624"/>
                <a:ext cx="1463041" cy="1463040"/>
              </a:xfrm>
              <a:prstGeom prst="ellipse">
                <a:avLst/>
              </a:prstGeom>
              <a:solidFill>
                <a:srgbClr val="FFA7A9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Oval 125">
                <a:extLst>
                  <a:ext uri="{FF2B5EF4-FFF2-40B4-BE49-F238E27FC236}">
                    <a16:creationId xmlns:a16="http://schemas.microsoft.com/office/drawing/2014/main" id="{BF77737B-2810-3E8A-66E9-8D95542FCE18}"/>
                  </a:ext>
                </a:extLst>
              </p:cNvPr>
              <p:cNvSpPr/>
              <p:nvPr/>
            </p:nvSpPr>
            <p:spPr>
              <a:xfrm>
                <a:off x="2286000" y="3794760"/>
                <a:ext cx="1463041" cy="1463040"/>
              </a:xfrm>
              <a:prstGeom prst="ellipse">
                <a:avLst/>
              </a:prstGeom>
              <a:solidFill>
                <a:schemeClr val="bg2">
                  <a:lumMod val="90000"/>
                  <a:alpha val="2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2DC7C13A-B8FD-40E5-903D-2E407E1478AB}"/>
                  </a:ext>
                </a:extLst>
              </p:cNvPr>
              <p:cNvSpPr txBox="1"/>
              <p:nvPr/>
            </p:nvSpPr>
            <p:spPr>
              <a:xfrm>
                <a:off x="1534802" y="4263987"/>
                <a:ext cx="814627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:756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61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Rectangle 127">
                <a:extLst>
                  <a:ext uri="{FF2B5EF4-FFF2-40B4-BE49-F238E27FC236}">
                    <a16:creationId xmlns:a16="http://schemas.microsoft.com/office/drawing/2014/main" id="{E07E0E84-F20D-7C0A-B125-0C97A7E20FAD}"/>
                  </a:ext>
                </a:extLst>
              </p:cNvPr>
              <p:cNvSpPr/>
              <p:nvPr/>
            </p:nvSpPr>
            <p:spPr>
              <a:xfrm>
                <a:off x="1164594" y="3607566"/>
                <a:ext cx="91563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nge Dose</a:t>
                </a:r>
              </a:p>
            </p:txBody>
          </p:sp>
          <p:sp>
            <p:nvSpPr>
              <p:cNvPr id="129" name="Oval 128">
                <a:extLst>
                  <a:ext uri="{FF2B5EF4-FFF2-40B4-BE49-F238E27FC236}">
                    <a16:creationId xmlns:a16="http://schemas.microsoft.com/office/drawing/2014/main" id="{C46B4413-CFF7-897F-DD8E-DD3FA72DAE3E}"/>
                  </a:ext>
                </a:extLst>
              </p:cNvPr>
              <p:cNvSpPr/>
              <p:nvPr/>
            </p:nvSpPr>
            <p:spPr>
              <a:xfrm>
                <a:off x="1920241" y="4608576"/>
                <a:ext cx="1463041" cy="1463040"/>
              </a:xfrm>
              <a:prstGeom prst="ellipse">
                <a:avLst/>
              </a:prstGeom>
              <a:solidFill>
                <a:srgbClr val="00B050">
                  <a:alpha val="30196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Rectangle 129">
                <a:extLst>
                  <a:ext uri="{FF2B5EF4-FFF2-40B4-BE49-F238E27FC236}">
                    <a16:creationId xmlns:a16="http://schemas.microsoft.com/office/drawing/2014/main" id="{66C8D87D-3D63-9ED9-3C74-1F1D5A5B2A07}"/>
                  </a:ext>
                </a:extLst>
              </p:cNvPr>
              <p:cNvSpPr/>
              <p:nvPr/>
            </p:nvSpPr>
            <p:spPr>
              <a:xfrm>
                <a:off x="2901825" y="5904591"/>
                <a:ext cx="69923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cebo</a:t>
                </a:r>
                <a:endParaRPr kumimoji="0" 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BAD14AE2-68DC-E93C-A6F1-E9EC0A1D4EEB}"/>
                  </a:ext>
                </a:extLst>
              </p:cNvPr>
              <p:cNvSpPr txBox="1"/>
              <p:nvPr/>
            </p:nvSpPr>
            <p:spPr>
              <a:xfrm>
                <a:off x="2288546" y="4104546"/>
                <a:ext cx="617187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: 47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5CB5753B-7BEB-C33E-CE4B-4C6E64B821C3}"/>
                  </a:ext>
                </a:extLst>
              </p:cNvPr>
              <p:cNvSpPr txBox="1"/>
              <p:nvPr/>
            </p:nvSpPr>
            <p:spPr>
              <a:xfrm>
                <a:off x="2891107" y="4055138"/>
                <a:ext cx="71317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: 545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B1191C7A-91D3-1916-77B0-35E34E31E6A3}"/>
                  </a:ext>
                </a:extLst>
              </p:cNvPr>
              <p:cNvSpPr txBox="1"/>
              <p:nvPr/>
            </p:nvSpPr>
            <p:spPr>
              <a:xfrm>
                <a:off x="1994622" y="4799214"/>
                <a:ext cx="675889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:24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19B4F15E-7584-57D6-C57E-30DED12203A6}"/>
                  </a:ext>
                </a:extLst>
              </p:cNvPr>
              <p:cNvSpPr txBox="1"/>
              <p:nvPr/>
            </p:nvSpPr>
            <p:spPr>
              <a:xfrm>
                <a:off x="2308442" y="5484514"/>
                <a:ext cx="8487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: 396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B5A02540-9A2C-FCB4-15A5-BDB30763375C}"/>
                  </a:ext>
                </a:extLst>
              </p:cNvPr>
              <p:cNvSpPr txBox="1"/>
              <p:nvPr/>
            </p:nvSpPr>
            <p:spPr>
              <a:xfrm>
                <a:off x="2384102" y="4565633"/>
                <a:ext cx="575131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:5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6D294271-C610-D424-9372-C73652667470}"/>
                  </a:ext>
                </a:extLst>
              </p:cNvPr>
              <p:cNvSpPr txBox="1"/>
              <p:nvPr/>
            </p:nvSpPr>
            <p:spPr>
              <a:xfrm>
                <a:off x="2753074" y="4718643"/>
                <a:ext cx="71139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:33 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)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DB7B10E2-1876-8202-0E96-475A0B047408}"/>
                </a:ext>
              </a:extLst>
            </p:cNvPr>
            <p:cNvSpPr/>
            <p:nvPr/>
          </p:nvSpPr>
          <p:spPr>
            <a:xfrm>
              <a:off x="7676169" y="587328"/>
              <a:ext cx="109517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edium Dos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3754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349</Words>
  <Application>Microsoft Office PowerPoint</Application>
  <PresentationFormat>Widescreen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rade Gothic Next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mindi Seneviratne</dc:creator>
  <cp:lastModifiedBy>Chamindi Seneviratne</cp:lastModifiedBy>
  <cp:revision>1</cp:revision>
  <dcterms:created xsi:type="dcterms:W3CDTF">2023-12-20T19:42:45Z</dcterms:created>
  <dcterms:modified xsi:type="dcterms:W3CDTF">2023-12-21T04:49:19Z</dcterms:modified>
</cp:coreProperties>
</file>